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colors5.xml" ContentType="application/vnd.ms-office.chartcolorstyle+xml"/>
  <Override PartName="/ppt/charts/colors6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charts/style5.xml" ContentType="application/vnd.ms-office.chartstyle+xml"/>
  <Override PartName="/ppt/charts/style6.xml" ContentType="application/vnd.ms-office.chartstyle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80" r:id="rId3"/>
    <p:sldId id="282" r:id="rId4"/>
    <p:sldId id="283" r:id="rId5"/>
    <p:sldId id="284" r:id="rId6"/>
    <p:sldId id="277" r:id="rId7"/>
    <p:sldId id="281" r:id="rId8"/>
  </p:sldIdLst>
  <p:sldSz cx="6858000" cy="9906000" type="A4"/>
  <p:notesSz cx="6858000" cy="9144000"/>
  <p:custDataLst>
    <p:tags r:id="rId1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33CC"/>
    <a:srgbClr val="D006B3"/>
    <a:srgbClr val="FEDEE3"/>
    <a:srgbClr val="F7E1EB"/>
    <a:srgbClr val="F0E3F1"/>
    <a:srgbClr val="EDDDDB"/>
    <a:srgbClr val="FCE4F5"/>
    <a:srgbClr val="FBD9DA"/>
    <a:srgbClr val="F49E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45" autoAdjust="0"/>
    <p:restoredTop sz="95214" autoAdjust="0"/>
  </p:normalViewPr>
  <p:slideViewPr>
    <p:cSldViewPr snapToGrid="0">
      <p:cViewPr>
        <p:scale>
          <a:sx n="150" d="100"/>
          <a:sy n="150" d="100"/>
        </p:scale>
        <p:origin x="-276" y="-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notesMaster" Target="notesMasters/notesMaster1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4" Type="http://schemas.openxmlformats.org/officeDocument/2006/relationships/tags" Target="tags/tag4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flh12\Desktop\T1DM%20and%20T2DM\T1DM%20high%20vs%20low\All%20canonical%20pathways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C:\Users\flh12\Desktop\T1DM%20and%20T2DM\T2DM%20high%20vs%20low\Canonical%20pathway_T2DM%20high%20vs%20low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C:\Users\flh12\Desktop\T1DM%20and%20T2DM\T1DM%20high%20vs%20wt%20high\cp1.xls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C:\Users\flh12\Desktop\T1DM%20and%20T2DM\T2DM%20high%20vs%20wt%20high\pathway.xls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C:\Users\flh12\Desktop\T1DM%20and%20T2DM\T1DM%20low%20vs%20wt%20low\cp1.xls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file:///C:\Users\flh12\Desktop\T1DM%20and%20T2DM\T2DM%20low%20vs%20wt%20low\pathway.tx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193895682162"/>
          <c:y val="0.0463549539738526"/>
          <c:w val="0.750752754995755"/>
          <c:h val="0.841547362078302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delete val="1"/>
          </c:dLbls>
          <c:cat>
            <c:strRef>
              <c:f>Sheet2!$B$2:$B$21</c:f>
              <c:strCache>
                <c:ptCount val="20"/>
                <c:pt idx="0">
                  <c:v>iCOS-iCOSL Signaling in T Helper Cells</c:v>
                </c:pt>
                <c:pt idx="1">
                  <c:v>PKCθ Signaling in T Lymphocytes</c:v>
                </c:pt>
                <c:pt idx="2">
                  <c:v>Calcium-induced T Lymphocyte Apoptosis</c:v>
                </c:pt>
                <c:pt idx="3">
                  <c:v>Calcium Signaling</c:v>
                </c:pt>
                <c:pt idx="4">
                  <c:v>Role of NFAT in Regulation of the Immune Response</c:v>
                </c:pt>
                <c:pt idx="5">
                  <c:v>Netrin Signaling</c:v>
                </c:pt>
                <c:pt idx="6">
                  <c:v>Cardiac Hypertrophy Signaling (Enhanced)</c:v>
                </c:pt>
                <c:pt idx="7">
                  <c:v>Endocannabinoid Neuronal Synapse Pathway</c:v>
                </c:pt>
                <c:pt idx="8">
                  <c:v>Cell Cycle Control of Chromosomal Replication</c:v>
                </c:pt>
                <c:pt idx="9">
                  <c:v>B Cell Receptor Signaling</c:v>
                </c:pt>
                <c:pt idx="10">
                  <c:v>Signaling by Rho Family GTPases</c:v>
                </c:pt>
                <c:pt idx="11">
                  <c:v>iNOS Signaling</c:v>
                </c:pt>
                <c:pt idx="12">
                  <c:v>Neuroinflammation Signaling Pathway</c:v>
                </c:pt>
                <c:pt idx="13">
                  <c:v>Toll-like Receptor Signaling</c:v>
                </c:pt>
                <c:pt idx="14">
                  <c:v>Corticotropin Releasing Hormone Signaling</c:v>
                </c:pt>
                <c:pt idx="15">
                  <c:v>Xenobiotic Metabolism PXR Signaling Pathway</c:v>
                </c:pt>
                <c:pt idx="16">
                  <c:v>Xenobiotic Metabolism AHR Signaling Pathway</c:v>
                </c:pt>
                <c:pt idx="17">
                  <c:v>Role of PKR in Interferon Induction and Antiviral Response</c:v>
                </c:pt>
                <c:pt idx="18">
                  <c:v>Interferon Signaling</c:v>
                </c:pt>
                <c:pt idx="19">
                  <c:v>PD-1, PD-L1 cancer immunotherapy pathway</c:v>
                </c:pt>
              </c:strCache>
            </c:strRef>
          </c:cat>
          <c:val>
            <c:numRef>
              <c:f>Sheet2!$C$2:$C$21</c:f>
              <c:numCache>
                <c:formatCode>General</c:formatCode>
                <c:ptCount val="20"/>
                <c:pt idx="0">
                  <c:v>-4.382</c:v>
                </c:pt>
                <c:pt idx="1">
                  <c:v>-3.781</c:v>
                </c:pt>
                <c:pt idx="2">
                  <c:v>-3.71</c:v>
                </c:pt>
                <c:pt idx="3">
                  <c:v>-3.272</c:v>
                </c:pt>
                <c:pt idx="4">
                  <c:v>-3.175</c:v>
                </c:pt>
                <c:pt idx="5">
                  <c:v>-3.153</c:v>
                </c:pt>
                <c:pt idx="6">
                  <c:v>-2.969</c:v>
                </c:pt>
                <c:pt idx="7">
                  <c:v>-2.921</c:v>
                </c:pt>
                <c:pt idx="8">
                  <c:v>-2.84</c:v>
                </c:pt>
                <c:pt idx="9">
                  <c:v>-2.795</c:v>
                </c:pt>
                <c:pt idx="10">
                  <c:v>1.151</c:v>
                </c:pt>
                <c:pt idx="11">
                  <c:v>1.155</c:v>
                </c:pt>
                <c:pt idx="12">
                  <c:v>1.477</c:v>
                </c:pt>
                <c:pt idx="13">
                  <c:v>1.508</c:v>
                </c:pt>
                <c:pt idx="14">
                  <c:v>1.633</c:v>
                </c:pt>
                <c:pt idx="15">
                  <c:v>1.64</c:v>
                </c:pt>
                <c:pt idx="16">
                  <c:v>1.789</c:v>
                </c:pt>
                <c:pt idx="17">
                  <c:v>2.6</c:v>
                </c:pt>
                <c:pt idx="18">
                  <c:v>3.051</c:v>
                </c:pt>
                <c:pt idx="19">
                  <c:v>3.4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69820832"/>
        <c:axId val="669829360"/>
      </c:barChart>
      <c:catAx>
        <c:axId val="66982083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669829360"/>
        <c:crosses val="autoZero"/>
        <c:auto val="1"/>
        <c:lblAlgn val="ctr"/>
        <c:lblOffset val="100"/>
        <c:noMultiLvlLbl val="0"/>
      </c:catAx>
      <c:valAx>
        <c:axId val="6698293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low"/>
        <c:spPr>
          <a:noFill/>
          <a:ln>
            <a:noFill/>
          </a:ln>
          <a:effectLst/>
        </c:spPr>
        <c:txPr>
          <a:bodyPr rot="0" spcFirstLastPara="1" vertOverflow="ellipsis" vert="horz" wrap="square" anchor="b" anchorCtr="0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669820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e2e6efaf-5e41-48c9-b070-1bdc64c4cbf9}"/>
      </c:ext>
    </c:extLst>
  </c:chart>
  <c:spPr>
    <a:noFill/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382707101754"/>
          <c:y val="0.02636938244775"/>
          <c:w val="0.761199881336868"/>
          <c:h val="0.75740929468823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delete val="1"/>
          </c:dLbls>
          <c:val>
            <c:numRef>
              <c:f>Sheet3!$E$2:$E$20</c:f>
              <c:numCache>
                <c:formatCode>General</c:formatCode>
                <c:ptCount val="19"/>
                <c:pt idx="0">
                  <c:v>-3.9</c:v>
                </c:pt>
                <c:pt idx="1">
                  <c:v>-3.719</c:v>
                </c:pt>
                <c:pt idx="2">
                  <c:v>-3.273</c:v>
                </c:pt>
                <c:pt idx="3">
                  <c:v>-3.138</c:v>
                </c:pt>
                <c:pt idx="4">
                  <c:v>-3.051</c:v>
                </c:pt>
                <c:pt idx="5">
                  <c:v>-2.887</c:v>
                </c:pt>
                <c:pt idx="6">
                  <c:v>-2.668</c:v>
                </c:pt>
                <c:pt idx="7">
                  <c:v>-2.534</c:v>
                </c:pt>
                <c:pt idx="8">
                  <c:v>-2.333</c:v>
                </c:pt>
                <c:pt idx="9">
                  <c:v>-2.324</c:v>
                </c:pt>
                <c:pt idx="10">
                  <c:v>1.387</c:v>
                </c:pt>
                <c:pt idx="11">
                  <c:v>1.414</c:v>
                </c:pt>
                <c:pt idx="12">
                  <c:v>1.508</c:v>
                </c:pt>
                <c:pt idx="13">
                  <c:v>1.633</c:v>
                </c:pt>
                <c:pt idx="14">
                  <c:v>2.121</c:v>
                </c:pt>
                <c:pt idx="15">
                  <c:v>2.236</c:v>
                </c:pt>
                <c:pt idx="16">
                  <c:v>2.324</c:v>
                </c:pt>
                <c:pt idx="17">
                  <c:v>2.53</c:v>
                </c:pt>
                <c:pt idx="18">
                  <c:v>3.1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52745376"/>
        <c:axId val="452745704"/>
      </c:barChart>
      <c:catAx>
        <c:axId val="452745376"/>
        <c:scaling>
          <c:orientation val="minMax"/>
        </c:scaling>
        <c:delete val="1"/>
        <c:axPos val="l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452745704"/>
        <c:crosses val="autoZero"/>
        <c:auto val="1"/>
        <c:lblAlgn val="ctr"/>
        <c:lblOffset val="100"/>
        <c:noMultiLvlLbl val="0"/>
      </c:catAx>
      <c:valAx>
        <c:axId val="45274570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452745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3e6de536-275f-4b78-9663-7b5d3690fad7}"/>
      </c:ext>
    </c:extLst>
  </c:chart>
  <c:spPr>
    <a:noFill/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150673450517"/>
          <c:y val="0.0421879613893027"/>
          <c:w val="0.665205132526498"/>
          <c:h val="0.791944747420046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delete val="1"/>
          </c:dLbls>
          <c:val>
            <c:numRef>
              <c:f>Sheet1!$D$2:$D$21</c:f>
              <c:numCache>
                <c:formatCode>General</c:formatCode>
                <c:ptCount val="20"/>
                <c:pt idx="0">
                  <c:v>-2.53</c:v>
                </c:pt>
                <c:pt idx="1">
                  <c:v>-2.138</c:v>
                </c:pt>
                <c:pt idx="2">
                  <c:v>-2</c:v>
                </c:pt>
                <c:pt idx="3">
                  <c:v>-2</c:v>
                </c:pt>
                <c:pt idx="4">
                  <c:v>-1.941</c:v>
                </c:pt>
                <c:pt idx="5">
                  <c:v>-1.732</c:v>
                </c:pt>
                <c:pt idx="6">
                  <c:v>-1.667</c:v>
                </c:pt>
                <c:pt idx="7">
                  <c:v>-1.667</c:v>
                </c:pt>
                <c:pt idx="8">
                  <c:v>-1.414</c:v>
                </c:pt>
                <c:pt idx="9">
                  <c:v>-1.414</c:v>
                </c:pt>
                <c:pt idx="10">
                  <c:v>0.333</c:v>
                </c:pt>
                <c:pt idx="11">
                  <c:v>0.447</c:v>
                </c:pt>
                <c:pt idx="12">
                  <c:v>0.447</c:v>
                </c:pt>
                <c:pt idx="13">
                  <c:v>0.707</c:v>
                </c:pt>
                <c:pt idx="14">
                  <c:v>0.707</c:v>
                </c:pt>
                <c:pt idx="15">
                  <c:v>0.816</c:v>
                </c:pt>
                <c:pt idx="16">
                  <c:v>0.816</c:v>
                </c:pt>
                <c:pt idx="17">
                  <c:v>1.342</c:v>
                </c:pt>
                <c:pt idx="18">
                  <c:v>1.414</c:v>
                </c:pt>
                <c:pt idx="19">
                  <c:v>1.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71779784"/>
        <c:axId val="671780112"/>
      </c:barChart>
      <c:catAx>
        <c:axId val="671779784"/>
        <c:scaling>
          <c:orientation val="minMax"/>
        </c:scaling>
        <c:delete val="1"/>
        <c:axPos val="l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671780112"/>
        <c:crosses val="autoZero"/>
        <c:auto val="1"/>
        <c:lblAlgn val="ctr"/>
        <c:lblOffset val="100"/>
        <c:noMultiLvlLbl val="0"/>
      </c:catAx>
      <c:valAx>
        <c:axId val="671780112"/>
        <c:scaling>
          <c:orientation val="minMax"/>
          <c:max val="3"/>
          <c:min val="-3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671779784"/>
        <c:crosses val="autoZero"/>
        <c:crossBetween val="between"/>
        <c:majorUnit val="3"/>
        <c:minorUnit val="3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446ba2a2-041c-42a7-9662-1d9150d95be0}"/>
      </c:ext>
    </c:extLst>
  </c:chart>
  <c:spPr>
    <a:noFill/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27203084293"/>
          <c:y val="0.0675429359371933"/>
          <c:w val="0.616661916215374"/>
          <c:h val="0.792308607645674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delete val="1"/>
          </c:dLbls>
          <c:val>
            <c:numRef>
              <c:f>Sheet1!$D$2:$D$13</c:f>
              <c:numCache>
                <c:formatCode>General</c:formatCode>
                <c:ptCount val="12"/>
                <c:pt idx="0">
                  <c:v>-5.516</c:v>
                </c:pt>
                <c:pt idx="1">
                  <c:v>-4.491</c:v>
                </c:pt>
                <c:pt idx="2">
                  <c:v>-4.359</c:v>
                </c:pt>
                <c:pt idx="3">
                  <c:v>-4.123</c:v>
                </c:pt>
                <c:pt idx="4">
                  <c:v>-3.9</c:v>
                </c:pt>
                <c:pt idx="5">
                  <c:v>-3.873</c:v>
                </c:pt>
                <c:pt idx="6">
                  <c:v>-3.71</c:v>
                </c:pt>
                <c:pt idx="7">
                  <c:v>-3.667</c:v>
                </c:pt>
                <c:pt idx="8">
                  <c:v>-3.606</c:v>
                </c:pt>
                <c:pt idx="9">
                  <c:v>-3.606</c:v>
                </c:pt>
                <c:pt idx="10">
                  <c:v>0.378</c:v>
                </c:pt>
                <c:pt idx="11">
                  <c:v>2.6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00687880"/>
        <c:axId val="500688864"/>
      </c:barChart>
      <c:catAx>
        <c:axId val="500687880"/>
        <c:scaling>
          <c:orientation val="minMax"/>
        </c:scaling>
        <c:delete val="1"/>
        <c:axPos val="l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500688864"/>
        <c:crosses val="autoZero"/>
        <c:auto val="1"/>
        <c:lblAlgn val="ctr"/>
        <c:lblOffset val="100"/>
        <c:noMultiLvlLbl val="0"/>
      </c:catAx>
      <c:valAx>
        <c:axId val="500688864"/>
        <c:scaling>
          <c:orientation val="minMax"/>
          <c:max val="3"/>
          <c:min val="-6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500687880"/>
        <c:crosses val="autoZero"/>
        <c:crossBetween val="between"/>
        <c:majorUnit val="3"/>
        <c:minorUnit val="3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1f59141c-4edd-4474-acb9-64dfab8ce478}"/>
      </c:ext>
    </c:extLst>
  </c:chart>
  <c:spPr>
    <a:noFill/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150508423931"/>
          <c:y val="0.0521187950373356"/>
          <c:w val="0.699914184672399"/>
          <c:h val="0.745790010558528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delete val="1"/>
          </c:dLbls>
          <c:val>
            <c:numRef>
              <c:f>Sheet1!$D$3:$D$22</c:f>
              <c:numCache>
                <c:formatCode>General</c:formatCode>
                <c:ptCount val="20"/>
                <c:pt idx="0">
                  <c:v>-2.111</c:v>
                </c:pt>
                <c:pt idx="1">
                  <c:v>-1.897</c:v>
                </c:pt>
                <c:pt idx="2">
                  <c:v>-1.89</c:v>
                </c:pt>
                <c:pt idx="3">
                  <c:v>-1.89</c:v>
                </c:pt>
                <c:pt idx="4">
                  <c:v>-1.667</c:v>
                </c:pt>
                <c:pt idx="5">
                  <c:v>-1.342</c:v>
                </c:pt>
                <c:pt idx="6">
                  <c:v>-1.342</c:v>
                </c:pt>
                <c:pt idx="7">
                  <c:v>-1.342</c:v>
                </c:pt>
                <c:pt idx="8">
                  <c:v>-1.342</c:v>
                </c:pt>
                <c:pt idx="9">
                  <c:v>-1.134</c:v>
                </c:pt>
                <c:pt idx="10">
                  <c:v>0.707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.265</c:v>
                </c:pt>
                <c:pt idx="17">
                  <c:v>1.265</c:v>
                </c:pt>
                <c:pt idx="18">
                  <c:v>1.342</c:v>
                </c:pt>
                <c:pt idx="19">
                  <c:v>1.6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46277712"/>
        <c:axId val="346271152"/>
      </c:barChart>
      <c:catAx>
        <c:axId val="346277712"/>
        <c:scaling>
          <c:orientation val="minMax"/>
        </c:scaling>
        <c:delete val="1"/>
        <c:axPos val="l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346271152"/>
        <c:crosses val="autoZero"/>
        <c:auto val="1"/>
        <c:lblAlgn val="ctr"/>
        <c:lblOffset val="100"/>
        <c:noMultiLvlLbl val="0"/>
      </c:catAx>
      <c:valAx>
        <c:axId val="346271152"/>
        <c:scaling>
          <c:orientation val="minMax"/>
          <c:max val="3"/>
          <c:min val="-3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346277712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6ca3c84e-e0b5-4cf4-982a-529ab8d6c8b8}"/>
      </c:ext>
    </c:extLst>
  </c:chart>
  <c:spPr>
    <a:noFill/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956547098279"/>
          <c:y val="0.0432389937106918"/>
          <c:w val="0.716821230679498"/>
          <c:h val="0.779094859604814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delete val="1"/>
          </c:dLbls>
          <c:val>
            <c:numRef>
              <c:f>Sheet1!$D$3:$D$22</c:f>
              <c:numCache>
                <c:formatCode>General</c:formatCode>
                <c:ptCount val="20"/>
                <c:pt idx="0">
                  <c:v>-2.828</c:v>
                </c:pt>
                <c:pt idx="1">
                  <c:v>-1.897</c:v>
                </c:pt>
                <c:pt idx="2">
                  <c:v>-1.633</c:v>
                </c:pt>
                <c:pt idx="3">
                  <c:v>-1.342</c:v>
                </c:pt>
                <c:pt idx="4">
                  <c:v>-1.291</c:v>
                </c:pt>
                <c:pt idx="5">
                  <c:v>-1.265</c:v>
                </c:pt>
                <c:pt idx="6">
                  <c:v>-1.155</c:v>
                </c:pt>
                <c:pt idx="7">
                  <c:v>-1.134</c:v>
                </c:pt>
                <c:pt idx="8">
                  <c:v>-1.069</c:v>
                </c:pt>
                <c:pt idx="9">
                  <c:v>-1</c:v>
                </c:pt>
                <c:pt idx="10">
                  <c:v>0.707</c:v>
                </c:pt>
                <c:pt idx="11">
                  <c:v>0.816</c:v>
                </c:pt>
                <c:pt idx="12">
                  <c:v>0.905</c:v>
                </c:pt>
                <c:pt idx="13">
                  <c:v>1</c:v>
                </c:pt>
                <c:pt idx="14">
                  <c:v>1</c:v>
                </c:pt>
                <c:pt idx="15">
                  <c:v>1.265</c:v>
                </c:pt>
                <c:pt idx="16">
                  <c:v>1.265</c:v>
                </c:pt>
                <c:pt idx="17">
                  <c:v>1.387</c:v>
                </c:pt>
                <c:pt idx="18">
                  <c:v>1.604</c:v>
                </c:pt>
                <c:pt idx="19">
                  <c:v>1.6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5919152"/>
        <c:axId val="515917184"/>
      </c:barChart>
      <c:catAx>
        <c:axId val="515919152"/>
        <c:scaling>
          <c:orientation val="minMax"/>
        </c:scaling>
        <c:delete val="1"/>
        <c:axPos val="l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515917184"/>
        <c:crosses val="autoZero"/>
        <c:auto val="1"/>
        <c:lblAlgn val="ctr"/>
        <c:lblOffset val="100"/>
        <c:noMultiLvlLbl val="0"/>
      </c:catAx>
      <c:valAx>
        <c:axId val="515917184"/>
        <c:scaling>
          <c:orientation val="minMax"/>
          <c:max val="3"/>
          <c:min val="-3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515919152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59edd546-5956-4fee-a2fb-fa1471981e73}"/>
      </c:ext>
    </c:extLst>
  </c:chart>
  <c:spPr>
    <a:noFill/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1FCF97-C03E-4CAC-B03E-1406CC253A8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A9393C-E4AC-447D-B82B-E456288E9ED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DDE0D7-ACFC-482F-8DD2-DE17A5EE609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793CF7-7248-452F-9B34-C650CF3799DE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347980" y="429895"/>
            <a:ext cx="6169660" cy="796290"/>
          </a:xfrm>
          <a:prstGeom prst="rect">
            <a:avLst/>
          </a:prstGeom>
        </p:spPr>
        <p:txBody>
          <a:bodyPr wrap="square">
            <a:noAutofit/>
          </a:bodyPr>
          <a:p>
            <a:pPr marL="0" indent="0" algn="ctr" defTabSz="266700">
              <a:spcBef>
                <a:spcPct val="0"/>
              </a:spcBef>
              <a:spcAft>
                <a:spcPts val="600"/>
              </a:spcAft>
            </a:pPr>
            <a:r>
              <a:rPr lang="en-US" altLang="zh-CN" sz="1400" b="1">
                <a:solidFill>
                  <a:srgbClr val="FF0000"/>
                </a:solidFill>
                <a:latin typeface="Arial" panose="020B0604020202020204"/>
                <a:ea typeface="Arial" panose="020B0604020202020204"/>
              </a:rPr>
              <a:t>E</a:t>
            </a:r>
            <a:r>
              <a:rPr lang="en-US" altLang="zh-CN" sz="1400" b="1">
                <a:solidFill>
                  <a:srgbClr val="FF0000"/>
                </a:solidFill>
                <a:latin typeface="Arial" panose="020B0604020202020204"/>
                <a:ea typeface="宋体" panose="02010600030101010101" pitchFamily="2" charset="-122"/>
              </a:rPr>
              <a:t>mpowered </a:t>
            </a:r>
            <a:r>
              <a:rPr lang="en-US" altLang="zh-CN" sz="1400" b="1">
                <a:solidFill>
                  <a:srgbClr val="FF0000"/>
                </a:solidFill>
                <a:latin typeface="Arial" panose="020B0604020202020204"/>
                <a:ea typeface="Arial" panose="020B0604020202020204"/>
              </a:rPr>
              <a:t>pro-inflammatory features in Ly6C monocytes and altered antigen-presenting capacity in Ly6C</a:t>
            </a:r>
            <a:r>
              <a:rPr lang="en-US" altLang="zh-CN" sz="1400" b="1" baseline="30000">
                <a:solidFill>
                  <a:srgbClr val="FF0000"/>
                </a:solidFill>
                <a:latin typeface="Arial" panose="020B0604020202020204"/>
                <a:ea typeface="Arial" panose="020B0604020202020204"/>
              </a:rPr>
              <a:t>high</a:t>
            </a:r>
            <a:r>
              <a:rPr lang="en-US" altLang="zh-CN" sz="1400" b="1">
                <a:solidFill>
                  <a:srgbClr val="FF0000"/>
                </a:solidFill>
                <a:latin typeface="Arial" panose="020B0604020202020204"/>
                <a:ea typeface="宋体" panose="02010600030101010101" pitchFamily="2" charset="-122"/>
              </a:rPr>
              <a:t> </a:t>
            </a:r>
            <a:r>
              <a:rPr lang="en-US" altLang="zh-CN" sz="1400" b="1">
                <a:solidFill>
                  <a:srgbClr val="FF0000"/>
                </a:solidFill>
                <a:latin typeface="Arial" panose="020B0604020202020204"/>
                <a:ea typeface="Arial" panose="020B0604020202020204"/>
              </a:rPr>
              <a:t>monocytes in diabetic mice</a:t>
            </a:r>
            <a:endParaRPr lang="en-US" altLang="zh-CN" sz="1400" b="1">
              <a:solidFill>
                <a:srgbClr val="FF0000"/>
              </a:solidFill>
              <a:latin typeface="Arial" panose="020B0604020202020204"/>
              <a:ea typeface="Arial" panose="020B0604020202020204"/>
            </a:endParaRPr>
          </a:p>
          <a:p>
            <a:pPr marL="0" indent="0" algn="just" defTabSz="266700">
              <a:spcBef>
                <a:spcPct val="0"/>
              </a:spcBef>
              <a:spcAft>
                <a:spcPts val="600"/>
              </a:spcAft>
            </a:pPr>
            <a:r>
              <a:rPr lang="en-US" altLang="zh-CN" sz="1200">
                <a:latin typeface="Arial" panose="020B0604020202020204"/>
                <a:ea typeface="宋体" panose="02010600030101010101" pitchFamily="2" charset="-122"/>
              </a:rPr>
              <a:t> </a:t>
            </a:r>
            <a:endParaRPr lang="en-US" altLang="zh-CN" sz="1200">
              <a:latin typeface="Arial" panose="020B0604020202020204"/>
              <a:ea typeface="宋体" panose="02010600030101010101" pitchFamily="2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72440" y="1401445"/>
            <a:ext cx="6045200" cy="50006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ingping Yang</a:t>
            </a:r>
            <a:r>
              <a:rPr kumimoji="0" lang="en-US" altLang="zh-CN" sz="1100" b="0" i="0" u="none" strike="noStrike" kern="1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,2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u Fang</a:t>
            </a:r>
            <a:r>
              <a:rPr lang="en-US" altLang="zh-CN" sz="1100" kern="100" baseline="30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kumimoji="0" lang="en-US" altLang="zh-CN" sz="11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izhe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Sun</a:t>
            </a:r>
            <a:r>
              <a:rPr kumimoji="0" lang="en-US" altLang="zh-CN" sz="1100" b="0" i="0" u="none" strike="noStrike" kern="1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,3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Lu Liu</a:t>
            </a:r>
            <a:r>
              <a:rPr kumimoji="0" lang="en-US" altLang="zh-CN" sz="1100" b="0" i="0" u="none" strike="noStrike" kern="1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100" kern="100" dirty="0" err="1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Linghua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 Fu</a:t>
            </a:r>
            <a:r>
              <a:rPr lang="en-US" altLang="zh-CN" sz="1100" kern="100" baseline="30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4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, 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ang 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Xi</a:t>
            </a:r>
            <a:r>
              <a:rPr kumimoji="0" lang="en-US" altLang="zh-CN" sz="1100" b="0" i="0" u="none" strike="noStrike" kern="1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100" kern="100" dirty="0" err="1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Xianwei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Wang</a:t>
            </a:r>
            <a:r>
              <a:rPr kumimoji="0" lang="en-US" altLang="zh-CN" sz="1100" b="0" i="0" u="none" strike="noStrike" kern="1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ihab Bouchare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qing Zhang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Qinghua Wu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Yong Ji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Xiaofeng Yang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Hong Wang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265430" algn="just" defTabSz="4572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 </a:t>
            </a:r>
            <a:endParaRPr kumimoji="0" lang="en-US" altLang="zh-CN" sz="11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marL="0" marR="0" lvl="0" indent="265430" algn="just" defTabSz="4572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100" b="0" i="0" u="none" strike="noStrike" kern="1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epartment of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ndocrinology and Metabolism, the Second Affiliated Hospital, Jiangxi Medical College, Nanchang University, Nanchang, Jiangxi, 330006, People’s Republic of China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endParaRPr kumimoji="0" lang="en-US" altLang="zh-CN" sz="11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marL="0" marR="0" lvl="0" indent="265430" algn="just" defTabSz="4572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100" b="0" i="0" u="none" strike="noStrike" kern="1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enter for Metabolic Disease Research, Department of Cardiovascular science, Lewis Kats School of Medicine, Temple University, Philadelphia, PA, USA.</a:t>
            </a:r>
            <a:endParaRPr kumimoji="0" lang="en-US" altLang="zh-CN" sz="11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marL="0" marR="0" lvl="0" indent="265430" algn="just" defTabSz="4572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100" b="0" i="0" u="none" strike="noStrike" kern="1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epartment of Cardiovascular Medicine, the First Affiliated Hospital of Xi'an </a:t>
            </a:r>
            <a:r>
              <a:rPr kumimoji="0" lang="en-US" altLang="zh-CN" sz="11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Jiaotong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University, Xi'an 710061, People’s Republic of China.</a:t>
            </a:r>
            <a:endParaRPr kumimoji="0" lang="en-US" altLang="zh-CN" sz="11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indent="265430" algn="just">
              <a:lnSpc>
                <a:spcPct val="150000"/>
              </a:lnSpc>
              <a:defRPr/>
            </a:pPr>
            <a:r>
              <a:rPr lang="en-US" altLang="zh-CN" sz="1100" kern="1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partments of</a:t>
            </a:r>
            <a:r>
              <a:rPr lang="en-US" altLang="zh-CN" sz="1100" kern="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diovascular Medicine, 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Second Affiliated Hospital, Jiangxi Medical College, Nanchang University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anchang, Jiangxi, 330006, People’s Republic of China.</a:t>
            </a:r>
            <a:endParaRPr lang="en-US" altLang="zh-CN" sz="1100" kern="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indent="265430" algn="just">
              <a:lnSpc>
                <a:spcPct val="150000"/>
              </a:lnSpc>
              <a:defRPr/>
            </a:pPr>
            <a:r>
              <a:rPr lang="en-US" altLang="zh-CN" sz="1100" kern="1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11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partment of Cardiology, Shengjing Hospital of China Medical University, Shenyang 110004, China.</a:t>
            </a:r>
            <a:endParaRPr lang="en-US" altLang="zh-CN" sz="1100" kern="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indent="265430" algn="just">
              <a:lnSpc>
                <a:spcPct val="150000"/>
              </a:lnSpc>
              <a:defRPr/>
            </a:pPr>
            <a:r>
              <a:rPr lang="en-US" altLang="zh-CN" sz="1100" kern="100" baseline="30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tate Key Laboratory of Frigid Zone Cardiovascular Diseases (SKLFZCD), Harbin Medical University, 157 </a:t>
            </a:r>
            <a:r>
              <a:rPr kumimoji="0" lang="en-US" altLang="zh-CN" sz="11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aojian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Rd, </a:t>
            </a:r>
            <a:r>
              <a:rPr kumimoji="0" lang="en-US" altLang="zh-CN" sz="11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angang</a:t>
            </a: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District, Harbin, Heilongjiang, 150081, China.</a:t>
            </a:r>
            <a:endParaRPr kumimoji="0" lang="en-US" altLang="zh-CN" sz="11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marL="0" marR="0" lvl="0" indent="265430" algn="just" defTabSz="4572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en-US" altLang="zh-CN" sz="11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marL="0" marR="0" lvl="0" indent="265430" algn="just" defTabSz="4572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1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*Correspondence should to Professor Hong Wang (Ph.D. &amp; M.D.); Center for Metabolic Disease Research, Lewis Kats School of Medicine, Medical Education and Research Building, Room 1060, 3500 N Broad St, Philadelphia, PA 19140 USA; E-mail: hong.wang@temple.edu.</a:t>
            </a:r>
            <a:endParaRPr kumimoji="0" lang="en-US" altLang="zh-CN" sz="11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57" name="TextBox 75"/>
          <p:cNvSpPr txBox="1"/>
          <p:nvPr/>
        </p:nvSpPr>
        <p:spPr>
          <a:xfrm>
            <a:off x="290121" y="523414"/>
            <a:ext cx="6078873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228600" indent="-228600">
              <a:buSzPct val="150000"/>
              <a:buFont typeface="+mj-lt"/>
              <a:buAutoNum type="alphaUcPeriod"/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indent="0">
              <a:buNone/>
            </a:pPr>
            <a:r>
              <a:rPr lang="en-US" altLang="zh-CN" sz="14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A. </a:t>
            </a:r>
            <a:r>
              <a:rPr lang="en-US" altLang="zh-CN" dirty="0">
                <a:solidFill>
                  <a:schemeClr val="tx1">
                    <a:lumMod val="95000"/>
                    <a:lumOff val="5000"/>
                  </a:schemeClr>
                </a:solidFill>
              </a:rPr>
              <a:t>Identification of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EG from </a:t>
            </a:r>
            <a:r>
              <a:rPr lang="en-US" altLang="zh-CN" dirty="0">
                <a:solidFill>
                  <a:schemeClr val="tx1">
                    <a:lumMod val="95000"/>
                    <a:lumOff val="5000"/>
                  </a:schemeClr>
                </a:solidFill>
              </a:rPr>
              <a:t>7 comparison groups </a:t>
            </a:r>
            <a:r>
              <a:rPr lang="en-US" altLang="zh-CN" sz="900" b="0" dirty="0">
                <a:latin typeface="Arial" panose="020B0604020202020204" pitchFamily="34" charset="0"/>
                <a:cs typeface="Arial" panose="020B0604020202020204" pitchFamily="34" charset="0"/>
              </a:rPr>
              <a:t>(DEG=|Log</a:t>
            </a:r>
            <a:r>
              <a:rPr lang="en-US" altLang="zh-CN" sz="900" b="0" baseline="-25000" dirty="0"/>
              <a:t>2</a:t>
            </a:r>
            <a:r>
              <a:rPr lang="en-US" altLang="zh-CN" sz="900" b="0" dirty="0">
                <a:latin typeface="Arial" panose="020B0604020202020204" pitchFamily="34" charset="0"/>
                <a:cs typeface="Arial" panose="020B0604020202020204" pitchFamily="34" charset="0"/>
              </a:rPr>
              <a:t>FC|&gt;1, adj. </a:t>
            </a:r>
            <a:r>
              <a:rPr lang="en-US" altLang="zh-CN" sz="900" b="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900" b="0" dirty="0">
                <a:latin typeface="Arial" panose="020B0604020202020204" pitchFamily="34" charset="0"/>
                <a:cs typeface="Arial" panose="020B0604020202020204" pitchFamily="34" charset="0"/>
              </a:rPr>
              <a:t>&lt;0.01)</a:t>
            </a:r>
            <a:endParaRPr lang="en-US" b="0" dirty="0"/>
          </a:p>
        </p:txBody>
      </p:sp>
      <p:sp>
        <p:nvSpPr>
          <p:cNvPr id="295" name="矩形 12"/>
          <p:cNvSpPr/>
          <p:nvPr/>
        </p:nvSpPr>
        <p:spPr>
          <a:xfrm>
            <a:off x="4835948" y="798278"/>
            <a:ext cx="1529996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685800">
              <a:defRPr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zh-CN" sz="800" b="0" i="0" u="none" strike="noStrike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y6C</a:t>
            </a:r>
            <a:r>
              <a:rPr lang="en-US" altLang="zh-CN" sz="800" b="0" i="0" u="none" strike="noStrike" baseline="300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igh</a:t>
            </a:r>
            <a:r>
              <a:rPr lang="en-US" altLang="zh-CN" sz="800" b="0" i="0" u="none" strike="noStrike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T1DM vs CT) </a:t>
            </a:r>
            <a:endParaRPr lang="en-US" altLang="zh-CN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矩形 80"/>
          <p:cNvSpPr/>
          <p:nvPr/>
        </p:nvSpPr>
        <p:spPr>
          <a:xfrm>
            <a:off x="3312772" y="771717"/>
            <a:ext cx="1688153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 Ly6C</a:t>
            </a:r>
            <a:r>
              <a:rPr lang="en-US" altLang="zh-CN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vs Ly6C</a:t>
            </a:r>
            <a:r>
              <a:rPr lang="en-US" altLang="zh-CN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T2DM</a:t>
            </a:r>
            <a:r>
              <a:rPr lang="en-US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</a:t>
            </a:r>
            <a:r>
              <a:rPr lang="en-US" altLang="zh-CN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矩形 13"/>
          <p:cNvSpPr/>
          <p:nvPr/>
        </p:nvSpPr>
        <p:spPr>
          <a:xfrm>
            <a:off x="3123731" y="2131939"/>
            <a:ext cx="2001182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685800">
              <a:defRPr/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altLang="zh-CN" sz="800" b="0" i="0" u="none" strike="noStrike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y6C</a:t>
            </a:r>
            <a:r>
              <a:rPr lang="de-DE" altLang="zh-CN" sz="800" b="0" i="0" u="none" strike="noStrike" baseline="300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ow </a:t>
            </a:r>
            <a:r>
              <a:rPr lang="de-DE" altLang="zh-CN" sz="800" b="0" i="0" u="none" strike="noStrike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T2DM vs CT)</a:t>
            </a:r>
            <a:endParaRPr lang="en-US" altLang="zh-CN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2" name="Group 23"/>
          <p:cNvGrpSpPr/>
          <p:nvPr/>
        </p:nvGrpSpPr>
        <p:grpSpPr>
          <a:xfrm>
            <a:off x="3360744" y="920341"/>
            <a:ext cx="1563284" cy="1187600"/>
            <a:chOff x="423636" y="3835142"/>
            <a:chExt cx="1563284" cy="1187600"/>
          </a:xfrm>
        </p:grpSpPr>
        <p:sp>
          <p:nvSpPr>
            <p:cNvPr id="304" name="矩形 12"/>
            <p:cNvSpPr/>
            <p:nvPr/>
          </p:nvSpPr>
          <p:spPr>
            <a:xfrm>
              <a:off x="523390" y="4822687"/>
              <a:ext cx="797310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b="0" i="0" u="none" strike="noStrike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2DM 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矩形 12"/>
            <p:cNvSpPr/>
            <p:nvPr/>
          </p:nvSpPr>
          <p:spPr>
            <a:xfrm>
              <a:off x="1076743" y="4822687"/>
              <a:ext cx="910177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CT 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8" name="Group 93"/>
            <p:cNvGrpSpPr/>
            <p:nvPr/>
          </p:nvGrpSpPr>
          <p:grpSpPr>
            <a:xfrm>
              <a:off x="423636" y="3835142"/>
              <a:ext cx="247389" cy="990836"/>
              <a:chOff x="271165" y="5407827"/>
              <a:chExt cx="247389" cy="1281279"/>
            </a:xfrm>
          </p:grpSpPr>
          <p:cxnSp>
            <p:nvCxnSpPr>
              <p:cNvPr id="319" name="Straight Connector 84"/>
              <p:cNvCxnSpPr/>
              <p:nvPr/>
            </p:nvCxnSpPr>
            <p:spPr>
              <a:xfrm flipH="1">
                <a:off x="464132" y="5428185"/>
                <a:ext cx="0" cy="5486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0" name="Straight Connector 367"/>
              <p:cNvCxnSpPr/>
              <p:nvPr/>
            </p:nvCxnSpPr>
            <p:spPr>
              <a:xfrm flipH="1">
                <a:off x="465153" y="6047007"/>
                <a:ext cx="0" cy="64008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1" name="TextBox 368"/>
              <p:cNvSpPr txBox="1"/>
              <p:nvPr/>
            </p:nvSpPr>
            <p:spPr>
              <a:xfrm rot="16200000">
                <a:off x="99019" y="6269571"/>
                <a:ext cx="6082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350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2" name="TextBox 87"/>
              <p:cNvSpPr txBox="1"/>
              <p:nvPr/>
            </p:nvSpPr>
            <p:spPr>
              <a:xfrm rot="16200000">
                <a:off x="99244" y="5579748"/>
                <a:ext cx="574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12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309" name="Straight Connector 307"/>
            <p:cNvCxnSpPr/>
            <p:nvPr/>
          </p:nvCxnSpPr>
          <p:spPr>
            <a:xfrm rot="16200000" flipH="1">
              <a:off x="935962" y="4590493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0" name="Straight Connector 328"/>
            <p:cNvCxnSpPr/>
            <p:nvPr/>
          </p:nvCxnSpPr>
          <p:spPr>
            <a:xfrm rot="16200000" flipH="1">
              <a:off x="1515245" y="4590493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23" name="Group 22"/>
          <p:cNvGrpSpPr/>
          <p:nvPr/>
        </p:nvGrpSpPr>
        <p:grpSpPr>
          <a:xfrm>
            <a:off x="1787783" y="775391"/>
            <a:ext cx="1701861" cy="1332550"/>
            <a:chOff x="3370195" y="3690192"/>
            <a:chExt cx="1701861" cy="1332550"/>
          </a:xfrm>
        </p:grpSpPr>
        <p:sp>
          <p:nvSpPr>
            <p:cNvPr id="331" name="矩形 80"/>
            <p:cNvSpPr/>
            <p:nvPr/>
          </p:nvSpPr>
          <p:spPr>
            <a:xfrm>
              <a:off x="3370195" y="3690192"/>
              <a:ext cx="170186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 Ly6C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vs Ly6C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T1DM)</a:t>
              </a:r>
              <a:endParaRPr lang="en-US" altLang="zh-CN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矩形 12"/>
            <p:cNvSpPr/>
            <p:nvPr/>
          </p:nvSpPr>
          <p:spPr>
            <a:xfrm>
              <a:off x="3483822" y="4822687"/>
              <a:ext cx="946797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T1DM</a:t>
              </a:r>
              <a:r>
                <a:rPr lang="en-US" altLang="zh-CN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矩形 13"/>
            <p:cNvSpPr/>
            <p:nvPr/>
          </p:nvSpPr>
          <p:spPr>
            <a:xfrm>
              <a:off x="4147370" y="4822687"/>
              <a:ext cx="871860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T1DM 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5" name="Group 397"/>
            <p:cNvGrpSpPr/>
            <p:nvPr/>
          </p:nvGrpSpPr>
          <p:grpSpPr>
            <a:xfrm>
              <a:off x="3486739" y="3811760"/>
              <a:ext cx="230833" cy="1030333"/>
              <a:chOff x="284692" y="5377593"/>
              <a:chExt cx="230833" cy="1332354"/>
            </a:xfrm>
          </p:grpSpPr>
          <p:cxnSp>
            <p:nvCxnSpPr>
              <p:cNvPr id="338" name="Straight Connector 398"/>
              <p:cNvCxnSpPr/>
              <p:nvPr/>
            </p:nvCxnSpPr>
            <p:spPr>
              <a:xfrm flipH="1">
                <a:off x="465153" y="5457682"/>
                <a:ext cx="0" cy="4572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9" name="Straight Connector 399"/>
              <p:cNvCxnSpPr/>
              <p:nvPr/>
            </p:nvCxnSpPr>
            <p:spPr>
              <a:xfrm flipH="1">
                <a:off x="465153" y="5978427"/>
                <a:ext cx="0" cy="73152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0" name="TextBox 400"/>
              <p:cNvSpPr txBox="1"/>
              <p:nvPr/>
            </p:nvSpPr>
            <p:spPr>
              <a:xfrm rot="16200000">
                <a:off x="86222" y="6174224"/>
                <a:ext cx="6277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75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1" name="TextBox 401"/>
              <p:cNvSpPr txBox="1"/>
              <p:nvPr/>
            </p:nvSpPr>
            <p:spPr>
              <a:xfrm rot="16200000">
                <a:off x="80067" y="5582218"/>
                <a:ext cx="64008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12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336" name="Straight Connector 339"/>
            <p:cNvCxnSpPr/>
            <p:nvPr/>
          </p:nvCxnSpPr>
          <p:spPr>
            <a:xfrm rot="16200000" flipH="1">
              <a:off x="3973308" y="4590493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7" name="Straight Connector 340"/>
            <p:cNvCxnSpPr/>
            <p:nvPr/>
          </p:nvCxnSpPr>
          <p:spPr>
            <a:xfrm rot="16200000" flipH="1">
              <a:off x="4593875" y="4590493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2" name="Group 21"/>
          <p:cNvGrpSpPr/>
          <p:nvPr/>
        </p:nvGrpSpPr>
        <p:grpSpPr>
          <a:xfrm>
            <a:off x="307963" y="775391"/>
            <a:ext cx="1701861" cy="1332550"/>
            <a:chOff x="4847875" y="3690192"/>
            <a:chExt cx="1701861" cy="1332550"/>
          </a:xfrm>
        </p:grpSpPr>
        <p:sp>
          <p:nvSpPr>
            <p:cNvPr id="344" name="矩形 80"/>
            <p:cNvSpPr/>
            <p:nvPr/>
          </p:nvSpPr>
          <p:spPr>
            <a:xfrm>
              <a:off x="4847875" y="3690192"/>
              <a:ext cx="170186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 Ly6C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vs Ly6C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CT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矩形 12"/>
            <p:cNvSpPr/>
            <p:nvPr/>
          </p:nvSpPr>
          <p:spPr>
            <a:xfrm>
              <a:off x="5055464" y="4822687"/>
              <a:ext cx="760324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CT 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矩形 13"/>
            <p:cNvSpPr/>
            <p:nvPr/>
          </p:nvSpPr>
          <p:spPr>
            <a:xfrm>
              <a:off x="5689665" y="4822687"/>
              <a:ext cx="653183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CT 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7" name="Group 402"/>
            <p:cNvGrpSpPr/>
            <p:nvPr/>
          </p:nvGrpSpPr>
          <p:grpSpPr>
            <a:xfrm>
              <a:off x="4901800" y="3862342"/>
              <a:ext cx="230833" cy="986605"/>
              <a:chOff x="277714" y="5443003"/>
              <a:chExt cx="230833" cy="1275808"/>
            </a:xfrm>
          </p:grpSpPr>
          <p:cxnSp>
            <p:nvCxnSpPr>
              <p:cNvPr id="350" name="Straight Connector 403"/>
              <p:cNvCxnSpPr/>
              <p:nvPr/>
            </p:nvCxnSpPr>
            <p:spPr>
              <a:xfrm flipH="1">
                <a:off x="465153" y="5457682"/>
                <a:ext cx="0" cy="5486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1" name="Straight Connector 404"/>
              <p:cNvCxnSpPr/>
              <p:nvPr/>
            </p:nvCxnSpPr>
            <p:spPr>
              <a:xfrm flipH="1">
                <a:off x="465153" y="6047007"/>
                <a:ext cx="0" cy="64008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2" name="TextBox 405"/>
              <p:cNvSpPr txBox="1"/>
              <p:nvPr/>
            </p:nvSpPr>
            <p:spPr>
              <a:xfrm rot="16200000">
                <a:off x="104987" y="6315252"/>
                <a:ext cx="57628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41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3" name="TextBox 406"/>
              <p:cNvSpPr txBox="1"/>
              <p:nvPr/>
            </p:nvSpPr>
            <p:spPr>
              <a:xfrm rot="16200000">
                <a:off x="73090" y="5647628"/>
                <a:ext cx="64008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23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348" name="Straight Connector 366"/>
            <p:cNvCxnSpPr/>
            <p:nvPr/>
          </p:nvCxnSpPr>
          <p:spPr>
            <a:xfrm rot="16200000" flipH="1">
              <a:off x="5410671" y="4590493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9" name="Straight Connector 373"/>
            <p:cNvCxnSpPr/>
            <p:nvPr/>
          </p:nvCxnSpPr>
          <p:spPr>
            <a:xfrm rot="16200000" flipH="1">
              <a:off x="6016257" y="4590493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64" name="矩形 13"/>
          <p:cNvSpPr/>
          <p:nvPr/>
        </p:nvSpPr>
        <p:spPr>
          <a:xfrm>
            <a:off x="3388186" y="3286565"/>
            <a:ext cx="922900" cy="20005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685800">
              <a:defRPr/>
            </a:pPr>
            <a:r>
              <a:rPr lang="en-US" altLang="zh-CN" sz="700" b="0" i="0" u="none" strike="noStrike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2DM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endParaRPr lang="en-US" altLang="zh-CN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矩形 13"/>
          <p:cNvSpPr/>
          <p:nvPr/>
        </p:nvSpPr>
        <p:spPr>
          <a:xfrm>
            <a:off x="3995622" y="3286565"/>
            <a:ext cx="949523" cy="20005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685800">
              <a:defRPr/>
            </a:pP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CT Ly6C</a:t>
            </a:r>
            <a:r>
              <a: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endParaRPr lang="en-US" altLang="zh-CN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7" name="Group 88"/>
          <p:cNvGrpSpPr/>
          <p:nvPr/>
        </p:nvGrpSpPr>
        <p:grpSpPr>
          <a:xfrm>
            <a:off x="3334048" y="2265066"/>
            <a:ext cx="230832" cy="1017334"/>
            <a:chOff x="430114" y="5523942"/>
            <a:chExt cx="230832" cy="1315545"/>
          </a:xfrm>
        </p:grpSpPr>
        <p:cxnSp>
          <p:nvCxnSpPr>
            <p:cNvPr id="372" name="Straight Connector 374"/>
            <p:cNvCxnSpPr/>
            <p:nvPr/>
          </p:nvCxnSpPr>
          <p:spPr>
            <a:xfrm flipH="1">
              <a:off x="617553" y="5610082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3" name="Straight Connector 380"/>
            <p:cNvCxnSpPr/>
            <p:nvPr/>
          </p:nvCxnSpPr>
          <p:spPr>
            <a:xfrm flipH="1">
              <a:off x="617553" y="6199407"/>
              <a:ext cx="0" cy="6400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4" name="TextBox 394"/>
            <p:cNvSpPr txBox="1"/>
            <p:nvPr/>
          </p:nvSpPr>
          <p:spPr>
            <a:xfrm rot="16200000">
              <a:off x="195768" y="6358160"/>
              <a:ext cx="6995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 fontAlgn="ctr"/>
              <a:r>
                <a: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35</a:t>
              </a:r>
              <a:endParaRPr lang="en-US" sz="9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5" name="TextBox 396"/>
            <p:cNvSpPr txBox="1"/>
            <p:nvPr/>
          </p:nvSpPr>
          <p:spPr>
            <a:xfrm rot="16200000">
              <a:off x="195769" y="5758287"/>
              <a:ext cx="699522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 fontAlgn="ctr"/>
              <a:r>
                <a: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0</a:t>
              </a:r>
              <a:endParaRPr lang="en-US" sz="9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cxnSp>
        <p:nvCxnSpPr>
          <p:cNvPr id="370" name="Straight Connector 330"/>
          <p:cNvCxnSpPr/>
          <p:nvPr/>
        </p:nvCxnSpPr>
        <p:spPr>
          <a:xfrm rot="16200000" flipH="1">
            <a:off x="3835661" y="3054371"/>
            <a:ext cx="0" cy="54864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1" name="Straight Connector 334"/>
          <p:cNvCxnSpPr/>
          <p:nvPr/>
        </p:nvCxnSpPr>
        <p:spPr>
          <a:xfrm rot="16200000" flipH="1">
            <a:off x="4423957" y="3054371"/>
            <a:ext cx="0" cy="54864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13" name="Group 21"/>
          <p:cNvGrpSpPr/>
          <p:nvPr/>
        </p:nvGrpSpPr>
        <p:grpSpPr>
          <a:xfrm>
            <a:off x="4826673" y="983150"/>
            <a:ext cx="1440797" cy="1149053"/>
            <a:chOff x="4902051" y="3873689"/>
            <a:chExt cx="1440797" cy="1149053"/>
          </a:xfrm>
        </p:grpSpPr>
        <p:sp>
          <p:nvSpPr>
            <p:cNvPr id="415" name="矩形 12"/>
            <p:cNvSpPr/>
            <p:nvPr/>
          </p:nvSpPr>
          <p:spPr>
            <a:xfrm>
              <a:off x="4929785" y="4822687"/>
              <a:ext cx="886003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T1DM 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矩形 13"/>
            <p:cNvSpPr/>
            <p:nvPr/>
          </p:nvSpPr>
          <p:spPr>
            <a:xfrm>
              <a:off x="5689665" y="4822687"/>
              <a:ext cx="653183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CT 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7" name="Group 402"/>
            <p:cNvGrpSpPr/>
            <p:nvPr/>
          </p:nvGrpSpPr>
          <p:grpSpPr>
            <a:xfrm>
              <a:off x="4902051" y="3873689"/>
              <a:ext cx="230832" cy="1026191"/>
              <a:chOff x="277965" y="5457681"/>
              <a:chExt cx="230832" cy="1326999"/>
            </a:xfrm>
          </p:grpSpPr>
          <p:cxnSp>
            <p:nvCxnSpPr>
              <p:cNvPr id="420" name="Straight Connector 403"/>
              <p:cNvCxnSpPr/>
              <p:nvPr/>
            </p:nvCxnSpPr>
            <p:spPr>
              <a:xfrm flipH="1">
                <a:off x="470868" y="5457681"/>
                <a:ext cx="0" cy="744843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4" name="Straight Connector 404"/>
              <p:cNvCxnSpPr/>
              <p:nvPr/>
            </p:nvCxnSpPr>
            <p:spPr>
              <a:xfrm flipH="1">
                <a:off x="471226" y="6244424"/>
                <a:ext cx="0" cy="46552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5" name="TextBox 405"/>
              <p:cNvSpPr txBox="1"/>
              <p:nvPr/>
            </p:nvSpPr>
            <p:spPr>
              <a:xfrm rot="16200000">
                <a:off x="105238" y="5728006"/>
                <a:ext cx="57628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0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6" name="TextBox 406"/>
              <p:cNvSpPr txBox="1"/>
              <p:nvPr/>
            </p:nvSpPr>
            <p:spPr>
              <a:xfrm rot="16200000">
                <a:off x="73340" y="6349224"/>
                <a:ext cx="64008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64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418" name="Straight Connector 366"/>
            <p:cNvCxnSpPr/>
            <p:nvPr/>
          </p:nvCxnSpPr>
          <p:spPr>
            <a:xfrm rot="16200000" flipH="1">
              <a:off x="5410671" y="4590493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9" name="Straight Connector 373"/>
            <p:cNvCxnSpPr/>
            <p:nvPr/>
          </p:nvCxnSpPr>
          <p:spPr>
            <a:xfrm rot="16200000" flipH="1">
              <a:off x="6016257" y="4590493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440" name="图片 439"/>
          <p:cNvPicPr>
            <a:picLocks noChangeAspect="1"/>
          </p:cNvPicPr>
          <p:nvPr/>
        </p:nvPicPr>
        <p:blipFill rotWithShape="1">
          <a:blip r:embed="rId1"/>
          <a:srcRect l="12638" t="1282" r="8536" b="16363"/>
          <a:stretch>
            <a:fillRect/>
          </a:stretch>
        </p:blipFill>
        <p:spPr>
          <a:xfrm>
            <a:off x="2115598" y="948726"/>
            <a:ext cx="1163994" cy="987214"/>
          </a:xfrm>
          <a:prstGeom prst="rect">
            <a:avLst/>
          </a:prstGeom>
        </p:spPr>
      </p:pic>
      <p:pic>
        <p:nvPicPr>
          <p:cNvPr id="443" name="图片 442"/>
          <p:cNvPicPr>
            <a:picLocks noChangeAspect="1"/>
          </p:cNvPicPr>
          <p:nvPr/>
        </p:nvPicPr>
        <p:blipFill rotWithShape="1">
          <a:blip r:embed="rId2"/>
          <a:srcRect l="11463" t="815" r="8032" b="16329"/>
          <a:stretch>
            <a:fillRect/>
          </a:stretch>
        </p:blipFill>
        <p:spPr>
          <a:xfrm>
            <a:off x="3574062" y="926220"/>
            <a:ext cx="1188721" cy="1013754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3"/>
          <a:srcRect l="11415" t="955" r="8044" b="17034"/>
          <a:stretch>
            <a:fillRect/>
          </a:stretch>
        </p:blipFill>
        <p:spPr>
          <a:xfrm flipH="1">
            <a:off x="5054197" y="969340"/>
            <a:ext cx="1186130" cy="986526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4"/>
          <a:srcRect l="11957" t="913" r="8184" b="13765"/>
          <a:stretch>
            <a:fillRect/>
          </a:stretch>
        </p:blipFill>
        <p:spPr>
          <a:xfrm>
            <a:off x="583204" y="943668"/>
            <a:ext cx="1194404" cy="983624"/>
          </a:xfrm>
          <a:prstGeom prst="rect">
            <a:avLst/>
          </a:prstGeom>
        </p:spPr>
      </p:pic>
      <p:grpSp>
        <p:nvGrpSpPr>
          <p:cNvPr id="16" name="组合 15"/>
          <p:cNvGrpSpPr/>
          <p:nvPr/>
        </p:nvGrpSpPr>
        <p:grpSpPr>
          <a:xfrm>
            <a:off x="367233" y="2124179"/>
            <a:ext cx="1560000" cy="1331875"/>
            <a:chOff x="1741476" y="5769800"/>
            <a:chExt cx="1560000" cy="1331875"/>
          </a:xfrm>
        </p:grpSpPr>
        <p:sp>
          <p:nvSpPr>
            <p:cNvPr id="362" name="矩形 12"/>
            <p:cNvSpPr/>
            <p:nvPr/>
          </p:nvSpPr>
          <p:spPr>
            <a:xfrm>
              <a:off x="1837946" y="6901620"/>
              <a:ext cx="797310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b="0" i="0" u="none" strike="noStrike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2DM 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矩形 12"/>
            <p:cNvSpPr/>
            <p:nvPr/>
          </p:nvSpPr>
          <p:spPr>
            <a:xfrm>
              <a:off x="2391299" y="6901620"/>
              <a:ext cx="910177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CT Ly6C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6" name="Group 93"/>
            <p:cNvGrpSpPr/>
            <p:nvPr/>
          </p:nvGrpSpPr>
          <p:grpSpPr>
            <a:xfrm>
              <a:off x="1741476" y="5952631"/>
              <a:ext cx="249739" cy="1024017"/>
              <a:chOff x="274449" y="5457682"/>
              <a:chExt cx="249739" cy="1324186"/>
            </a:xfrm>
          </p:grpSpPr>
          <p:cxnSp>
            <p:nvCxnSpPr>
              <p:cNvPr id="376" name="Straight Connector 84"/>
              <p:cNvCxnSpPr/>
              <p:nvPr/>
            </p:nvCxnSpPr>
            <p:spPr>
              <a:xfrm flipH="1">
                <a:off x="465153" y="5457682"/>
                <a:ext cx="0" cy="5486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7" name="Straight Connector 367"/>
              <p:cNvCxnSpPr/>
              <p:nvPr/>
            </p:nvCxnSpPr>
            <p:spPr>
              <a:xfrm flipH="1">
                <a:off x="465153" y="6047007"/>
                <a:ext cx="0" cy="64008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78" name="TextBox 368"/>
              <p:cNvSpPr txBox="1"/>
              <p:nvPr/>
            </p:nvSpPr>
            <p:spPr>
              <a:xfrm rot="16200000">
                <a:off x="85746" y="5685003"/>
                <a:ext cx="6082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82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9" name="TextBox 87"/>
              <p:cNvSpPr txBox="1"/>
              <p:nvPr/>
            </p:nvSpPr>
            <p:spPr>
              <a:xfrm rot="16200000">
                <a:off x="121435" y="6379115"/>
                <a:ext cx="574674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 fontAlgn="ctr"/>
                <a:r>
                  <a: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95</a:t>
                </a:r>
                <a:endParaRPr lang="en-US" sz="9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368" name="Straight Connector 307"/>
            <p:cNvCxnSpPr/>
            <p:nvPr/>
          </p:nvCxnSpPr>
          <p:spPr>
            <a:xfrm rot="16200000" flipH="1">
              <a:off x="2250518" y="6669426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9" name="Straight Connector 328"/>
            <p:cNvCxnSpPr/>
            <p:nvPr/>
          </p:nvCxnSpPr>
          <p:spPr>
            <a:xfrm rot="16200000" flipH="1">
              <a:off x="2829801" y="6669426"/>
              <a:ext cx="0" cy="5486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1" name="矩形 12"/>
            <p:cNvSpPr/>
            <p:nvPr/>
          </p:nvSpPr>
          <p:spPr>
            <a:xfrm>
              <a:off x="1842251" y="5769800"/>
              <a:ext cx="133614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altLang="zh-CN" sz="800" b="0" i="0" u="none" strike="noStrike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y6C</a:t>
              </a:r>
              <a:r>
                <a:rPr lang="en-US" altLang="zh-CN" sz="800" b="0" i="0" u="none" strike="noStrike" baseline="300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igh</a:t>
              </a:r>
              <a:r>
                <a:rPr lang="en-US" altLang="zh-CN" sz="800" b="0" i="0" u="none" strike="noStrike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(T2DM vs CT)</a:t>
              </a:r>
              <a:endParaRPr lang="en-US" altLang="zh-CN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图片 25"/>
            <p:cNvPicPr>
              <a:picLocks noChangeAspect="1"/>
            </p:cNvPicPr>
            <p:nvPr/>
          </p:nvPicPr>
          <p:blipFill rotWithShape="1">
            <a:blip r:embed="rId5"/>
            <a:srcRect l="11739" t="1726" r="7669" b="15873"/>
            <a:stretch>
              <a:fillRect/>
            </a:stretch>
          </p:blipFill>
          <p:spPr>
            <a:xfrm flipH="1">
              <a:off x="1964833" y="5948934"/>
              <a:ext cx="1186947" cy="986603"/>
            </a:xfrm>
            <a:prstGeom prst="rect">
              <a:avLst/>
            </a:prstGeom>
          </p:spPr>
        </p:pic>
      </p:grpSp>
      <p:grpSp>
        <p:nvGrpSpPr>
          <p:cNvPr id="25" name="组合 24"/>
          <p:cNvGrpSpPr/>
          <p:nvPr/>
        </p:nvGrpSpPr>
        <p:grpSpPr>
          <a:xfrm>
            <a:off x="1877513" y="2115272"/>
            <a:ext cx="1535408" cy="1340287"/>
            <a:chOff x="-1604839" y="5664676"/>
            <a:chExt cx="1535408" cy="1340287"/>
          </a:xfrm>
        </p:grpSpPr>
        <p:sp>
          <p:nvSpPr>
            <p:cNvPr id="296" name="矩形 13"/>
            <p:cNvSpPr/>
            <p:nvPr/>
          </p:nvSpPr>
          <p:spPr>
            <a:xfrm>
              <a:off x="-1521419" y="5664676"/>
              <a:ext cx="133369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ctr" defTabSz="685800">
                <a:defRPr/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de-DE" altLang="zh-CN" sz="800" b="0" i="0" u="none" strike="noStrike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y6C</a:t>
              </a:r>
              <a:r>
                <a:rPr lang="de-DE" altLang="zh-CN" sz="800" b="0" i="0" u="none" strike="noStrike" baseline="300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ow </a:t>
              </a:r>
              <a:r>
                <a:rPr lang="de-DE" altLang="zh-CN" sz="800" b="0" i="0" u="none" strike="noStrike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(T1DM vs CT) </a:t>
              </a:r>
              <a:endParaRPr lang="en-US" altLang="zh-CN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0" name="Group 22"/>
            <p:cNvGrpSpPr/>
            <p:nvPr/>
          </p:nvGrpSpPr>
          <p:grpSpPr>
            <a:xfrm>
              <a:off x="-1604839" y="5793981"/>
              <a:ext cx="1535408" cy="1210982"/>
              <a:chOff x="3483822" y="3811760"/>
              <a:chExt cx="1535408" cy="1210982"/>
            </a:xfrm>
          </p:grpSpPr>
          <p:sp>
            <p:nvSpPr>
              <p:cNvPr id="385" name="矩形 12"/>
              <p:cNvSpPr/>
              <p:nvPr/>
            </p:nvSpPr>
            <p:spPr>
              <a:xfrm>
                <a:off x="3483822" y="4822687"/>
                <a:ext cx="946797" cy="20005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lvl="0" algn="ctr" defTabSz="685800">
                  <a:defRPr/>
                </a:pPr>
                <a:r>
                  <a:rPr lang="en-US" altLang="zh-CN" sz="700" b="0" i="0" u="none" strike="noStrike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T1DM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Ly6C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  <a:endPara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6" name="矩形 13"/>
              <p:cNvSpPr/>
              <p:nvPr/>
            </p:nvSpPr>
            <p:spPr>
              <a:xfrm>
                <a:off x="4147370" y="4822687"/>
                <a:ext cx="871860" cy="20005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lvl="0" algn="ctr" defTabSz="685800">
                  <a:defRPr/>
                </a:pPr>
                <a:r>
                  <a:rPr lang="en-US" altLang="zh-CN" sz="7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poE</a:t>
                </a:r>
                <a:r>
                  <a:rPr lang="en-US" altLang="zh-CN" sz="7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 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y6C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  <a:endPara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87" name="Group 397"/>
              <p:cNvGrpSpPr/>
              <p:nvPr/>
            </p:nvGrpSpPr>
            <p:grpSpPr>
              <a:xfrm>
                <a:off x="3486739" y="3811760"/>
                <a:ext cx="230833" cy="1030333"/>
                <a:chOff x="284692" y="5377593"/>
                <a:chExt cx="230833" cy="1332354"/>
              </a:xfrm>
            </p:grpSpPr>
            <p:cxnSp>
              <p:nvCxnSpPr>
                <p:cNvPr id="390" name="Straight Connector 398"/>
                <p:cNvCxnSpPr/>
                <p:nvPr/>
              </p:nvCxnSpPr>
              <p:spPr>
                <a:xfrm flipH="1">
                  <a:off x="465153" y="5457682"/>
                  <a:ext cx="0" cy="45720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91" name="Straight Connector 399"/>
                <p:cNvCxnSpPr/>
                <p:nvPr/>
              </p:nvCxnSpPr>
              <p:spPr>
                <a:xfrm flipH="1">
                  <a:off x="465153" y="5978427"/>
                  <a:ext cx="0" cy="73152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05" name="TextBox 400"/>
                <p:cNvSpPr txBox="1"/>
                <p:nvPr/>
              </p:nvSpPr>
              <p:spPr>
                <a:xfrm rot="16200000">
                  <a:off x="86222" y="6174224"/>
                  <a:ext cx="6277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 fontAlgn="ctr"/>
                  <a:r>
                    <a:rPr lang="en-US" sz="900" b="0" i="0" u="none" strike="noStrike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56</a:t>
                  </a:r>
                  <a:endPara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07" name="TextBox 401"/>
                <p:cNvSpPr txBox="1"/>
                <p:nvPr/>
              </p:nvSpPr>
              <p:spPr>
                <a:xfrm rot="16200000">
                  <a:off x="80067" y="5582218"/>
                  <a:ext cx="64008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 rtl="0" fontAlgn="ctr"/>
                  <a:r>
                    <a:rPr lang="en-US" sz="900" b="0" i="0" u="none" strike="noStrike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55</a:t>
                  </a:r>
                  <a:endParaRPr lang="en-US" sz="9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cxnSp>
            <p:nvCxnSpPr>
              <p:cNvPr id="388" name="Straight Connector 339"/>
              <p:cNvCxnSpPr/>
              <p:nvPr/>
            </p:nvCxnSpPr>
            <p:spPr>
              <a:xfrm rot="16200000" flipH="1">
                <a:off x="3973308" y="4590493"/>
                <a:ext cx="0" cy="5486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9" name="Straight Connector 340"/>
              <p:cNvCxnSpPr/>
              <p:nvPr/>
            </p:nvCxnSpPr>
            <p:spPr>
              <a:xfrm rot="16200000" flipH="1">
                <a:off x="4593875" y="4590493"/>
                <a:ext cx="0" cy="5486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28" name="图片 27"/>
            <p:cNvPicPr>
              <a:picLocks noChangeAspect="1"/>
            </p:cNvPicPr>
            <p:nvPr/>
          </p:nvPicPr>
          <p:blipFill rotWithShape="1">
            <a:blip r:embed="rId6"/>
            <a:srcRect l="11463" t="876" r="8032" b="16777"/>
            <a:stretch>
              <a:fillRect/>
            </a:stretch>
          </p:blipFill>
          <p:spPr>
            <a:xfrm flipH="1">
              <a:off x="-1389718" y="5837709"/>
              <a:ext cx="1180641" cy="986603"/>
            </a:xfrm>
            <a:prstGeom prst="rect">
              <a:avLst/>
            </a:prstGeom>
          </p:spPr>
        </p:pic>
      </p:grpSp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7"/>
          <a:srcRect l="11617" t="785" r="8249" b="16014"/>
          <a:stretch>
            <a:fillRect/>
          </a:stretch>
        </p:blipFill>
        <p:spPr>
          <a:xfrm flipH="1">
            <a:off x="3542041" y="2320337"/>
            <a:ext cx="1188715" cy="989971"/>
          </a:xfrm>
          <a:prstGeom prst="rect">
            <a:avLst/>
          </a:prstGeom>
        </p:spPr>
      </p:pic>
      <p:grpSp>
        <p:nvGrpSpPr>
          <p:cNvPr id="37" name="组合 36"/>
          <p:cNvGrpSpPr/>
          <p:nvPr/>
        </p:nvGrpSpPr>
        <p:grpSpPr>
          <a:xfrm>
            <a:off x="5047402" y="2264856"/>
            <a:ext cx="701440" cy="1006096"/>
            <a:chOff x="5306645" y="7251463"/>
            <a:chExt cx="701440" cy="1006096"/>
          </a:xfrm>
        </p:grpSpPr>
        <p:grpSp>
          <p:nvGrpSpPr>
            <p:cNvPr id="354" name="Group 411"/>
            <p:cNvGrpSpPr/>
            <p:nvPr/>
          </p:nvGrpSpPr>
          <p:grpSpPr>
            <a:xfrm>
              <a:off x="5306645" y="7251463"/>
              <a:ext cx="701440" cy="1006096"/>
              <a:chOff x="1673965" y="438100"/>
              <a:chExt cx="419415" cy="647105"/>
            </a:xfrm>
          </p:grpSpPr>
          <p:sp>
            <p:nvSpPr>
              <p:cNvPr id="357" name="TextBox 83"/>
              <p:cNvSpPr txBox="1"/>
              <p:nvPr/>
            </p:nvSpPr>
            <p:spPr>
              <a:xfrm>
                <a:off x="1828234" y="446628"/>
                <a:ext cx="265146" cy="6385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500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ct val="1500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ct val="1500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ct val="1500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ct val="1500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6" name="文本框 258"/>
              <p:cNvSpPr txBox="1"/>
              <p:nvPr/>
            </p:nvSpPr>
            <p:spPr>
              <a:xfrm rot="16200000">
                <a:off x="1460538" y="651527"/>
                <a:ext cx="564875" cy="1380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z-score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444" name="图片 443"/>
            <p:cNvPicPr>
              <a:picLocks noChangeAspect="1"/>
            </p:cNvPicPr>
            <p:nvPr/>
          </p:nvPicPr>
          <p:blipFill rotWithShape="1">
            <a:blip r:embed="rId7"/>
            <a:srcRect l="92769" t="741" r="5002" b="68175"/>
            <a:stretch>
              <a:fillRect/>
            </a:stretch>
          </p:blipFill>
          <p:spPr>
            <a:xfrm>
              <a:off x="5498814" y="7366244"/>
              <a:ext cx="84144" cy="867797"/>
            </a:xfrm>
            <a:prstGeom prst="rect">
              <a:avLst/>
            </a:prstGeom>
          </p:spPr>
        </p:pic>
      </p:grpSp>
      <p:sp>
        <p:nvSpPr>
          <p:cNvPr id="248" name="TextBox 42"/>
          <p:cNvSpPr txBox="1"/>
          <p:nvPr/>
        </p:nvSpPr>
        <p:spPr>
          <a:xfrm>
            <a:off x="374650" y="3597275"/>
            <a:ext cx="5991225" cy="55308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Arial" panose="020B0604020202020204"/>
                <a:ea typeface="宋体" panose="02010600030101010101" pitchFamily="2" charset="-122"/>
                <a:sym typeface="+mn-ea"/>
              </a:rPr>
              <a:t>Supplementary </a:t>
            </a:r>
            <a:r>
              <a:rPr lang="en-US" sz="1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gure 1. 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eatmap of DEG in 7 comparison group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atmap shows the  expression levels of the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EG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Ly6C MC subsets identified by</a:t>
            </a: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 studio analysi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color density indicates the average expression of a given gene normalized by z-score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291965" y="0"/>
            <a:ext cx="268986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600" b="1">
                <a:latin typeface="Arial" panose="020B0604020202020204"/>
                <a:ea typeface="宋体" panose="02010600030101010101" pitchFamily="2" charset="-122"/>
                <a:sym typeface="+mn-ea"/>
              </a:rPr>
              <a:t>Supplementary Figure </a:t>
            </a:r>
            <a:r>
              <a:rPr lang="en-US" altLang="zh-CN" sz="1600" b="1">
                <a:latin typeface="Arial" panose="020B0604020202020204"/>
                <a:ea typeface="Arial" panose="020B0604020202020204"/>
                <a:sym typeface="+mn-ea"/>
              </a:rPr>
              <a:t>1</a:t>
            </a:r>
            <a:endParaRPr lang="en-US" altLang="zh-CN" sz="1600" b="1" i="0" u="none" strike="noStrike" dirty="0">
              <a:solidFill>
                <a:srgbClr val="4472C4"/>
              </a:solidFill>
              <a:effectLst/>
              <a:latin typeface="Arial" panose="020B0604020202020204"/>
              <a:ea typeface="Arial" panose="020B0604020202020204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87" name="Rectangle 5"/>
          <p:cNvSpPr/>
          <p:nvPr/>
        </p:nvSpPr>
        <p:spPr>
          <a:xfrm>
            <a:off x="442847" y="507305"/>
            <a:ext cx="3255582" cy="3539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op 10 changed pathways in T1DM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     (vs T1DM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900" dirty="0"/>
          </a:p>
        </p:txBody>
      </p:sp>
      <p:graphicFrame>
        <p:nvGraphicFramePr>
          <p:cNvPr id="88" name="图表 87"/>
          <p:cNvGraphicFramePr/>
          <p:nvPr/>
        </p:nvGraphicFramePr>
        <p:xfrm>
          <a:off x="2604392" y="911823"/>
          <a:ext cx="913976" cy="2618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260898" y="1026205"/>
          <a:ext cx="2431893" cy="2204220"/>
        </p:xfrm>
        <a:graphic>
          <a:graphicData uri="http://schemas.openxmlformats.org/drawingml/2006/table">
            <a:tbl>
              <a:tblPr/>
              <a:tblGrid>
                <a:gridCol w="2431893"/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PD-1/PD-L1 </a:t>
                      </a:r>
                      <a:r>
                        <a:rPr lang="en-US" altLang="zh-CN" sz="700" b="1" i="0" u="none" strike="noStrike" dirty="0">
                          <a:effectLst/>
                          <a:latin typeface="Arial" panose="020B0604020202020204" pitchFamily="34" charset="0"/>
                        </a:rPr>
                        <a:t>immune checkpoint</a:t>
                      </a:r>
                      <a:endParaRPr lang="en-US" altLang="zh-CN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Interferon </a:t>
                      </a:r>
                      <a:r>
                        <a:rPr lang="en-US" altLang="zh-CN" sz="700" b="1" i="0" u="none" strike="noStrike" dirty="0">
                          <a:effectLst/>
                          <a:latin typeface="Arial" panose="020B0604020202020204" pitchFamily="34" charset="0"/>
                        </a:rPr>
                        <a:t>s</a:t>
                      </a:r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ignaling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PKR in IFN induction </a:t>
                      </a:r>
                      <a:r>
                        <a:rPr lang="en-US" altLang="zh-C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&amp; </a:t>
                      </a:r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antiviral response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Xenobiotic metabolism AHR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Xenobiotic metabolism PXR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Corticotropin releasing hormone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Toll-like receptor signaling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Neuroinflammation signaling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 err="1">
                          <a:effectLst/>
                          <a:latin typeface="Arial" panose="020B0604020202020204" pitchFamily="34" charset="0"/>
                        </a:rPr>
                        <a:t>iNOS</a:t>
                      </a:r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 signaling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Signaling by Rho family GTPases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B cell receptor signaling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Cell cycle control of chromosomal replicatio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Endocannabinoid neuronal synapse pathway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Cardiac hypertrophy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Netrin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NFAT in regulation of the immune response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Calcium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Calcium-induced T cell apoptosis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PKC</a:t>
                      </a:r>
                      <a:r>
                        <a:rPr lang="el-GR" sz="700" b="1" i="0" u="none" strike="noStrike" dirty="0">
                          <a:effectLst/>
                          <a:latin typeface="Arial" panose="020B0604020202020204" pitchFamily="34" charset="0"/>
                        </a:rPr>
                        <a:t>θ </a:t>
                      </a:r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signaling in T cell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 err="1">
                          <a:effectLst/>
                          <a:latin typeface="Arial" panose="020B0604020202020204" pitchFamily="34" charset="0"/>
                        </a:rPr>
                        <a:t>iCOS-iCOSL</a:t>
                      </a:r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 signaling in Th cell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531" marR="3531" marT="353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2" name="文本框 91"/>
          <p:cNvSpPr txBox="1"/>
          <p:nvPr/>
        </p:nvSpPr>
        <p:spPr>
          <a:xfrm>
            <a:off x="2606115" y="853378"/>
            <a:ext cx="8836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omparison 2 </a:t>
            </a:r>
            <a:endParaRPr lang="zh-CN" altLang="en-US" sz="800" dirty="0"/>
          </a:p>
        </p:txBody>
      </p:sp>
      <p:graphicFrame>
        <p:nvGraphicFramePr>
          <p:cNvPr id="93" name="图表 92"/>
          <p:cNvGraphicFramePr/>
          <p:nvPr/>
        </p:nvGraphicFramePr>
        <p:xfrm>
          <a:off x="5497888" y="919818"/>
          <a:ext cx="953961" cy="28897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表格 5"/>
          <p:cNvGraphicFramePr>
            <a:graphicFrameLocks noGrp="1"/>
          </p:cNvGraphicFramePr>
          <p:nvPr/>
        </p:nvGraphicFramePr>
        <p:xfrm>
          <a:off x="3643030" y="959238"/>
          <a:ext cx="1954763" cy="2198600"/>
        </p:xfrm>
        <a:graphic>
          <a:graphicData uri="http://schemas.openxmlformats.org/drawingml/2006/table">
            <a:tbl>
              <a:tblPr/>
              <a:tblGrid>
                <a:gridCol w="1954763"/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xidative Phosphorylation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D-1/PD-L1 </a:t>
                      </a:r>
                      <a:r>
                        <a:rPr lang="en-US" altLang="zh-CN" sz="700" b="1" i="0" u="none" strike="noStrike" dirty="0">
                          <a:effectLst/>
                          <a:latin typeface="Arial" panose="020B0604020202020204" pitchFamily="34" charset="0"/>
                        </a:rPr>
                        <a:t>immune checkpoint</a:t>
                      </a:r>
                      <a:endParaRPr lang="en-US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ycolysis I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Unfolded protein respons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uanosine nucleotides degradation III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uconeogenesis I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ac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atty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cid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Î²-oxidation I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icosanoid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riacylglycerol biosynthesi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etrin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R5 signaling in macrophages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C maturation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LE in B cell signal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ondroitin sulfate biosynthesi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ell cycle control of chromosomal replication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COS-iCOSL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signaling in Th cells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L-7 signal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rdiac hypertrophy signal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lcium-induced T cell apoptosis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5" name="Rectangle 5"/>
          <p:cNvSpPr/>
          <p:nvPr/>
        </p:nvSpPr>
        <p:spPr>
          <a:xfrm>
            <a:off x="3535534" y="507305"/>
            <a:ext cx="3619388" cy="3539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op 10 changed pathways in T2DM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 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   (vs T2DM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900" dirty="0"/>
          </a:p>
        </p:txBody>
      </p:sp>
      <p:sp>
        <p:nvSpPr>
          <p:cNvPr id="97" name="文本框 96"/>
          <p:cNvSpPr txBox="1"/>
          <p:nvPr/>
        </p:nvSpPr>
        <p:spPr>
          <a:xfrm>
            <a:off x="5568233" y="807917"/>
            <a:ext cx="8836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omparison 3 </a:t>
            </a:r>
            <a:endParaRPr lang="zh-CN" altLang="en-US" sz="800" dirty="0"/>
          </a:p>
        </p:txBody>
      </p:sp>
      <p:graphicFrame>
        <p:nvGraphicFramePr>
          <p:cNvPr id="98" name="图表 97"/>
          <p:cNvGraphicFramePr/>
          <p:nvPr/>
        </p:nvGraphicFramePr>
        <p:xfrm>
          <a:off x="2485629" y="3650282"/>
          <a:ext cx="1097705" cy="2622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表格 6"/>
          <p:cNvGraphicFramePr>
            <a:graphicFrameLocks noGrp="1"/>
          </p:cNvGraphicFramePr>
          <p:nvPr/>
        </p:nvGraphicFramePr>
        <p:xfrm>
          <a:off x="471439" y="3794977"/>
          <a:ext cx="2195195" cy="2046660"/>
        </p:xfrm>
        <a:graphic>
          <a:graphicData uri="http://schemas.openxmlformats.org/drawingml/2006/table">
            <a:tbl>
              <a:tblPr/>
              <a:tblGrid>
                <a:gridCol w="2195195"/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Endocannabinoid </a:t>
                      </a:r>
                      <a:r>
                        <a:rPr lang="en-US" altLang="zh-CN" sz="650" b="0" i="0" u="none" strike="noStrike" dirty="0">
                          <a:effectLst/>
                          <a:latin typeface="Arial" panose="020B0604020202020204" pitchFamily="34" charset="0"/>
                        </a:rPr>
                        <a:t>c</a:t>
                      </a:r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ancer inhibition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1" i="0" u="none" strike="noStrike" dirty="0">
                          <a:effectLst/>
                          <a:latin typeface="Arial" panose="020B0604020202020204" pitchFamily="34" charset="0"/>
                        </a:rPr>
                        <a:t>NK cell signaling</a:t>
                      </a:r>
                      <a:endParaRPr lang="en-US" sz="65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1" i="0" u="none" strike="noStrike" dirty="0">
                          <a:effectLst/>
                          <a:latin typeface="Arial" panose="020B0604020202020204" pitchFamily="34" charset="0"/>
                        </a:rPr>
                        <a:t>CCR5 signaling in macrophages</a:t>
                      </a:r>
                      <a:endParaRPr lang="en-US" sz="65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Reelin signaling in neurons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GP6 signaling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1" i="0" u="none" strike="noStrike" dirty="0">
                          <a:effectLst/>
                          <a:latin typeface="Arial" panose="020B0604020202020204" pitchFamily="34" charset="0"/>
                        </a:rPr>
                        <a:t>PD-1/PD-L1 </a:t>
                      </a:r>
                      <a:r>
                        <a:rPr lang="en-US" altLang="zh-CN" sz="650" b="1" i="0" u="none" strike="noStrike" dirty="0">
                          <a:effectLst/>
                          <a:latin typeface="Arial" panose="020B0604020202020204" pitchFamily="34" charset="0"/>
                        </a:rPr>
                        <a:t>immune checkpoint</a:t>
                      </a:r>
                      <a:endParaRPr lang="en-US" altLang="zh-CN" sz="65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Epithelial mesenchymal </a:t>
                      </a:r>
                      <a:r>
                        <a:rPr lang="en-US" altLang="zh-CN" sz="650" b="0" i="0" u="none" strike="noStrike" dirty="0">
                          <a:effectLst/>
                          <a:latin typeface="Arial" panose="020B0604020202020204" pitchFamily="34" charset="0"/>
                        </a:rPr>
                        <a:t>t</a:t>
                      </a:r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ransition by GF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T2DM signaling</a:t>
                      </a:r>
                      <a:endParaRPr lang="en-US" sz="6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Renin-angiotensin signaling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1" i="0" u="none" strike="noStrike" dirty="0">
                          <a:effectLst/>
                          <a:latin typeface="Arial" panose="020B0604020202020204" pitchFamily="34" charset="0"/>
                        </a:rPr>
                        <a:t>IL-15 production</a:t>
                      </a:r>
                      <a:endParaRPr lang="en-US" sz="65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PI3K signaling in B cell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 err="1">
                          <a:effectLst/>
                          <a:latin typeface="Arial" panose="020B0604020202020204" pitchFamily="34" charset="0"/>
                        </a:rPr>
                        <a:t>Cardiogenesis</a:t>
                      </a:r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altLang="zh-CN" sz="650" b="0" i="0" u="none" strike="noStrike" dirty="0">
                          <a:effectLst/>
                          <a:latin typeface="Arial" panose="020B0604020202020204" pitchFamily="34" charset="0"/>
                        </a:rPr>
                        <a:t>factors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1" i="0" u="none" strike="noStrike" dirty="0">
                          <a:effectLst/>
                          <a:latin typeface="Arial" panose="020B0604020202020204" pitchFamily="34" charset="0"/>
                        </a:rPr>
                        <a:t>T cell exhaustion signaling</a:t>
                      </a:r>
                      <a:endParaRPr lang="en-US" sz="65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Xenobiotic metabolism CAR signaling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Xenobiotic metabolism PXR signaling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1" i="0" u="none" strike="noStrike" dirty="0">
                          <a:effectLst/>
                          <a:latin typeface="Arial" panose="020B0604020202020204" pitchFamily="34" charset="0"/>
                        </a:rPr>
                        <a:t>SLE in B cell signaling </a:t>
                      </a:r>
                      <a:endParaRPr lang="en-US" sz="65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GM-CSF signaling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0" i="0" u="none" strike="noStrike" dirty="0">
                          <a:effectLst/>
                          <a:latin typeface="Arial" panose="020B0604020202020204" pitchFamily="34" charset="0"/>
                        </a:rPr>
                        <a:t>Cell cycle control of chromosomal replication</a:t>
                      </a:r>
                      <a:endParaRPr lang="en-US" sz="65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1" i="0" u="none" strike="noStrike" dirty="0">
                          <a:effectLst/>
                          <a:latin typeface="Arial" panose="020B0604020202020204" pitchFamily="34" charset="0"/>
                        </a:rPr>
                        <a:t>NFAT regulation in the immune response</a:t>
                      </a:r>
                      <a:endParaRPr lang="en-US" sz="65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650" b="1" i="0" u="none" strike="noStrike" dirty="0">
                          <a:effectLst/>
                          <a:latin typeface="Arial" panose="020B0604020202020204" pitchFamily="34" charset="0"/>
                        </a:rPr>
                        <a:t>B cell receptor signaling</a:t>
                      </a:r>
                      <a:endParaRPr lang="en-US" sz="65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273" marR="3273" marT="32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2584420" y="3592339"/>
            <a:ext cx="8836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omparison 4 </a:t>
            </a:r>
            <a:endParaRPr lang="zh-CN" altLang="en-US" sz="800" dirty="0"/>
          </a:p>
        </p:txBody>
      </p:sp>
      <p:sp>
        <p:nvSpPr>
          <p:cNvPr id="101" name="Rectangle 5"/>
          <p:cNvSpPr/>
          <p:nvPr/>
        </p:nvSpPr>
        <p:spPr>
          <a:xfrm>
            <a:off x="442847" y="3398586"/>
            <a:ext cx="3312644" cy="3539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op 10 changed pathways in T1DM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     (vs CT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)</a:t>
            </a:r>
            <a:endParaRPr lang="en-US" sz="900" dirty="0"/>
          </a:p>
        </p:txBody>
      </p:sp>
      <p:sp>
        <p:nvSpPr>
          <p:cNvPr id="22" name="Rectangle 5"/>
          <p:cNvSpPr/>
          <p:nvPr/>
        </p:nvSpPr>
        <p:spPr>
          <a:xfrm>
            <a:off x="3513910" y="3398586"/>
            <a:ext cx="3243373" cy="3539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op 10 changed pathways in T2DM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   (vs CT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)</a:t>
            </a:r>
            <a:endParaRPr lang="en-US" sz="900" dirty="0"/>
          </a:p>
        </p:txBody>
      </p:sp>
      <p:graphicFrame>
        <p:nvGraphicFramePr>
          <p:cNvPr id="23" name="图表 22"/>
          <p:cNvGraphicFramePr/>
          <p:nvPr/>
        </p:nvGraphicFramePr>
        <p:xfrm>
          <a:off x="5412383" y="3788717"/>
          <a:ext cx="1199886" cy="22354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表格 23"/>
          <p:cNvGraphicFramePr>
            <a:graphicFrameLocks noGrp="1"/>
          </p:cNvGraphicFramePr>
          <p:nvPr/>
        </p:nvGraphicFramePr>
        <p:xfrm>
          <a:off x="3292304" y="3870824"/>
          <a:ext cx="2294548" cy="1844006"/>
        </p:xfrm>
        <a:graphic>
          <a:graphicData uri="http://schemas.openxmlformats.org/drawingml/2006/table">
            <a:tbl>
              <a:tblPr/>
              <a:tblGrid>
                <a:gridCol w="2294548"/>
              </a:tblGrid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PD-1/PD-L1 immune checkpoint</a:t>
                      </a:r>
                      <a:endParaRPr lang="en-US" sz="7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Melatonin Degradation </a:t>
                      </a:r>
                      <a:r>
                        <a:rPr lang="en-US" sz="700" b="0" i="0" u="none" strike="noStrike" dirty="0" err="1">
                          <a:effectLst/>
                          <a:latin typeface="Arial" panose="020B0604020202020204" pitchFamily="34" charset="0"/>
                        </a:rPr>
                        <a:t>superpathway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IL-7 signaling</a:t>
                      </a:r>
                      <a:endParaRPr lang="en-US" sz="700" b="1" i="0" u="none" strike="sng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Necroptosis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Cardiac hypertrophy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Phospholipase C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PKC</a:t>
                      </a:r>
                      <a:r>
                        <a:rPr lang="el-GR" sz="700" b="1" i="0" u="none" strike="noStrike" dirty="0">
                          <a:effectLst/>
                          <a:latin typeface="Arial" panose="020B0604020202020204" pitchFamily="34" charset="0"/>
                        </a:rPr>
                        <a:t>θ </a:t>
                      </a:r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signaling in T cell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Th1 pathway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 err="1">
                          <a:effectLst/>
                          <a:latin typeface="Arial" panose="020B0604020202020204" pitchFamily="34" charset="0"/>
                        </a:rPr>
                        <a:t>iCOS-iCOSL</a:t>
                      </a:r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 signaling in T helper cells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NFAT regulation </a:t>
                      </a:r>
                      <a:r>
                        <a:rPr lang="en-US" altLang="zh-CN" sz="700" b="1" i="0" u="none" strike="noStrike" dirty="0">
                          <a:effectLst/>
                          <a:latin typeface="Arial" panose="020B0604020202020204" pitchFamily="34" charset="0"/>
                        </a:rPr>
                        <a:t>in</a:t>
                      </a:r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 immune response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DC maturation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SLE In B cell signaling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52" marR="5552" marT="55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25" name="文本框 24"/>
          <p:cNvSpPr txBox="1"/>
          <p:nvPr/>
        </p:nvSpPr>
        <p:spPr>
          <a:xfrm>
            <a:off x="5558847" y="3668120"/>
            <a:ext cx="8836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omparison 5 </a:t>
            </a:r>
            <a:endParaRPr lang="zh-CN" altLang="en-US" sz="800" dirty="0"/>
          </a:p>
        </p:txBody>
      </p:sp>
      <p:sp>
        <p:nvSpPr>
          <p:cNvPr id="26" name="Rectangle 5"/>
          <p:cNvSpPr/>
          <p:nvPr/>
        </p:nvSpPr>
        <p:spPr>
          <a:xfrm>
            <a:off x="410498" y="6018870"/>
            <a:ext cx="3237033" cy="3539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op 10 changed pathways in T1DM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   (vs CT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)</a:t>
            </a:r>
            <a:endParaRPr lang="en-US" sz="900" dirty="0"/>
          </a:p>
        </p:txBody>
      </p:sp>
      <p:graphicFrame>
        <p:nvGraphicFramePr>
          <p:cNvPr id="27" name="图表 26"/>
          <p:cNvGraphicFramePr/>
          <p:nvPr/>
        </p:nvGraphicFramePr>
        <p:xfrm>
          <a:off x="2436696" y="6312326"/>
          <a:ext cx="1097706" cy="28498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8" name="表格 27"/>
          <p:cNvGraphicFramePr>
            <a:graphicFrameLocks noGrp="1"/>
          </p:cNvGraphicFramePr>
          <p:nvPr/>
        </p:nvGraphicFramePr>
        <p:xfrm>
          <a:off x="186144" y="6383890"/>
          <a:ext cx="2393850" cy="2199760"/>
        </p:xfrm>
        <a:graphic>
          <a:graphicData uri="http://schemas.openxmlformats.org/drawingml/2006/table">
            <a:tbl>
              <a:tblPr/>
              <a:tblGrid>
                <a:gridCol w="2393850"/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IL-7 signaling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Neuropathic pain signaling </a:t>
                      </a:r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i</a:t>
                      </a:r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n dorsal horn neurons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DC maturation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SLE in B Cell Signaling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Inhibition of matrix metalloproteases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i="0" u="none" strike="noStrike" dirty="0">
                          <a:effectLst/>
                          <a:latin typeface="Arial" panose="020B0604020202020204" pitchFamily="34" charset="0"/>
                        </a:rPr>
                        <a:t>NFAT in regulation of the immune response</a:t>
                      </a:r>
                      <a:endParaRPr lang="en-US" sz="7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Growth hormone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PRR recognition in bacteria and viruses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>
                          <a:effectLst/>
                          <a:latin typeface="Arial" panose="020B0604020202020204" pitchFamily="34" charset="0"/>
                        </a:rPr>
                        <a:t>Sumoylation</a:t>
                      </a:r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 pathway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Synaptic long-term depressio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Xenobiotic metabolism AHR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Thyroid hormone metabolism II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Nicotine degradation III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Melatonin degradation I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Nicotine degradation II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cAMP-mediated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>
                          <a:effectLst/>
                          <a:latin typeface="Arial" panose="020B0604020202020204" pitchFamily="34" charset="0"/>
                        </a:rPr>
                        <a:t>Superpathway</a:t>
                      </a:r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 of melatonin degradation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G</a:t>
                      </a:r>
                      <a:r>
                        <a:rPr lang="el-GR" sz="700" b="0" i="0" u="none" strike="noStrike" dirty="0">
                          <a:effectLst/>
                          <a:latin typeface="Arial" panose="020B0604020202020204" pitchFamily="34" charset="0"/>
                        </a:rPr>
                        <a:t>α</a:t>
                      </a:r>
                      <a:r>
                        <a:rPr lang="en-US" sz="700" b="0" i="0" u="none" strike="noStrike" dirty="0" err="1">
                          <a:effectLst/>
                          <a:latin typeface="Arial" panose="020B0604020202020204" pitchFamily="34" charset="0"/>
                        </a:rPr>
                        <a:t>i</a:t>
                      </a:r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Xenobiotic metabolism CAR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Xenobiotic metabolism PXR signaling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308" marR="3308" marT="330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29" name="文本框 28"/>
          <p:cNvSpPr txBox="1"/>
          <p:nvPr/>
        </p:nvSpPr>
        <p:spPr>
          <a:xfrm>
            <a:off x="2554321" y="6268279"/>
            <a:ext cx="883616" cy="123111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omparison 6 </a:t>
            </a:r>
            <a:endParaRPr lang="zh-CN" altLang="en-US" sz="800" dirty="0"/>
          </a:p>
        </p:txBody>
      </p:sp>
      <p:sp>
        <p:nvSpPr>
          <p:cNvPr id="30" name="Rectangle 162"/>
          <p:cNvSpPr/>
          <p:nvPr/>
        </p:nvSpPr>
        <p:spPr>
          <a:xfrm>
            <a:off x="2567646" y="8707356"/>
            <a:ext cx="80168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-score</a:t>
            </a:r>
            <a:endParaRPr lang="en-US" sz="8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5"/>
          <p:cNvSpPr/>
          <p:nvPr/>
        </p:nvSpPr>
        <p:spPr>
          <a:xfrm>
            <a:off x="3534402" y="5987120"/>
            <a:ext cx="3011690" cy="3539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op 10 changed pathways in T2DM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MC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   (vs CT Ly6C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ow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C)</a:t>
            </a:r>
            <a:endParaRPr lang="en-US" sz="900" dirty="0"/>
          </a:p>
        </p:txBody>
      </p:sp>
      <p:graphicFrame>
        <p:nvGraphicFramePr>
          <p:cNvPr id="32" name="表格 31"/>
          <p:cNvGraphicFramePr>
            <a:graphicFrameLocks noGrp="1"/>
          </p:cNvGraphicFramePr>
          <p:nvPr/>
        </p:nvGraphicFramePr>
        <p:xfrm>
          <a:off x="3619805" y="6388246"/>
          <a:ext cx="1976287" cy="2195100"/>
        </p:xfrm>
        <a:graphic>
          <a:graphicData uri="http://schemas.openxmlformats.org/drawingml/2006/table">
            <a:tbl>
              <a:tblPr/>
              <a:tblGrid>
                <a:gridCol w="1976287"/>
              </a:tblGrid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ryl hydrocarbon receptor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C maturation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MP-mediated signaling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 cell exhaustion signal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MGB1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PR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recognition in bacteria and viruse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atty acid</a:t>
                      </a: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xidation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hrombin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L-7 signal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emokine signal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umoricidal function of hepatic NK cells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pithelial mesenchymal transition By GF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phingosine-1-phosphate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ntegrin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eelin signaling in neuron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olorectal cancer metastasis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nterferon signal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HOP1 in Alzheimer’s diseas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ioblastoma multiforme signalin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K cell signaling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075" marR="3075" marT="30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33" name="图表 32"/>
          <p:cNvGraphicFramePr/>
          <p:nvPr/>
        </p:nvGraphicFramePr>
        <p:xfrm>
          <a:off x="5436169" y="6278450"/>
          <a:ext cx="1028700" cy="2792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4" name="文本框 33"/>
          <p:cNvSpPr txBox="1"/>
          <p:nvPr/>
        </p:nvSpPr>
        <p:spPr>
          <a:xfrm>
            <a:off x="5546328" y="6268279"/>
            <a:ext cx="883616" cy="123111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omparison 7 </a:t>
            </a:r>
            <a:endParaRPr lang="zh-CN" altLang="en-US" sz="800" b="1" dirty="0"/>
          </a:p>
        </p:txBody>
      </p:sp>
      <p:sp>
        <p:nvSpPr>
          <p:cNvPr id="35" name="Rectangle 162"/>
          <p:cNvSpPr/>
          <p:nvPr/>
        </p:nvSpPr>
        <p:spPr>
          <a:xfrm>
            <a:off x="5541205" y="8707356"/>
            <a:ext cx="80168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-score</a:t>
            </a:r>
            <a:endParaRPr lang="en-US" sz="8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261"/>
          <p:cNvSpPr>
            <a:spLocks noChangeArrowheads="1"/>
          </p:cNvSpPr>
          <p:nvPr/>
        </p:nvSpPr>
        <p:spPr bwMode="auto">
          <a:xfrm>
            <a:off x="4667250" y="43180"/>
            <a:ext cx="2443480" cy="215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/>
                <a:ea typeface="宋体" panose="02010600030101010101" pitchFamily="2" charset="-122"/>
                <a:sym typeface="+mn-ea"/>
              </a:rPr>
              <a:t>Supplementary Figure 2</a:t>
            </a:r>
            <a:endParaRPr lang="en-US" altLang="en-US" sz="1400" b="1" dirty="0"/>
          </a:p>
        </p:txBody>
      </p:sp>
      <p:sp>
        <p:nvSpPr>
          <p:cNvPr id="38" name="TextBox 1"/>
          <p:cNvSpPr txBox="1"/>
          <p:nvPr/>
        </p:nvSpPr>
        <p:spPr>
          <a:xfrm>
            <a:off x="186055" y="8944610"/>
            <a:ext cx="657098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defRPr/>
            </a:pPr>
            <a:r>
              <a:rPr lang="en-US" altLang="zh-CN" sz="900" b="1">
                <a:latin typeface="Arial" panose="020B0604020202020204"/>
                <a:ea typeface="宋体" panose="02010600030101010101" pitchFamily="2" charset="-122"/>
                <a:sym typeface="+mn-ea"/>
              </a:rPr>
              <a:t>Supplementary Figure 2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. Canonical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thway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alysis for DEG genes in six comparison groups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op 10 up/down changed pathway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Top up/down changed canonical pathways were identified by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using IPA software with the criteria of adjusted P value&lt;0.05 and demonstrated using z-score.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1DM Ly6C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vs T1DM Ly6C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en-US" altLang="zh-CN" sz="9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2DM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Ly6C</a:t>
            </a:r>
            <a:r>
              <a:rPr kumimoji="0" lang="en-US" altLang="zh-CN" sz="90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igh 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s </a:t>
            </a:r>
            <a:r>
              <a:rPr lang="en-US" altLang="zh-CN" sz="9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2DM 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y6C</a:t>
            </a:r>
            <a:r>
              <a:rPr kumimoji="0" lang="en-US" altLang="zh-CN" sz="90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ow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;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kumimoji="0" lang="en-US" altLang="zh-CN" sz="9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y6C</a:t>
            </a:r>
            <a:r>
              <a:rPr kumimoji="0" lang="en-US" altLang="zh-CN" sz="90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igh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</a:t>
            </a:r>
            <a:r>
              <a:rPr lang="en-US" altLang="zh-CN" sz="9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1DM</a:t>
            </a:r>
            <a:r>
              <a:rPr lang="en-US" altLang="zh-CN" sz="900" i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s CT);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0" lang="en-US" altLang="zh-CN" sz="9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y6C</a:t>
            </a:r>
            <a:r>
              <a:rPr kumimoji="0" lang="en-US" altLang="zh-CN" sz="90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igh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</a:t>
            </a:r>
            <a:r>
              <a:rPr lang="en-US" altLang="zh-CN" sz="9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2DM</a:t>
            </a:r>
            <a:r>
              <a:rPr lang="en-US" altLang="zh-CN" sz="900" i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s CT);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1DM</a:t>
            </a:r>
            <a:r>
              <a: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vs CT);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2DM</a:t>
            </a:r>
            <a:r>
              <a:rPr lang="en-US" altLang="zh-CN" sz="900" i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vs CT). Red and blue bars indicate positive and negative z-score for up- and down-regulated pathway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old letters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ighlight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mmunological pathways. 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528763" y="667934"/>
          <a:ext cx="2844000" cy="4898450"/>
        </p:xfrm>
        <a:graphic>
          <a:graphicData uri="http://schemas.openxmlformats.org/drawingml/2006/table">
            <a:tbl>
              <a:tblPr/>
              <a:tblGrid>
                <a:gridCol w="396000"/>
                <a:gridCol w="288000"/>
                <a:gridCol w="360000"/>
                <a:gridCol w="360000"/>
                <a:gridCol w="360000"/>
                <a:gridCol w="360000"/>
                <a:gridCol w="360000"/>
                <a:gridCol w="360000"/>
              </a:tblGrid>
              <a:tr h="252000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ytokine ligand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 Ly6C</a:t>
                      </a:r>
                      <a:r>
                        <a:rPr lang="en-US" sz="7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gh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:Ly6C</a:t>
                      </a:r>
                      <a:r>
                        <a:rPr lang="en-US" sz="7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w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/>
                </a:tc>
                <a:tc hMerge="1"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M </a:t>
                      </a:r>
                      <a:r>
                        <a:rPr lang="en-US" altLang="zh-C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Ly6C</a:t>
                      </a:r>
                      <a:r>
                        <a:rPr lang="en-US" altLang="zh-CN" sz="700" b="1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high</a:t>
                      </a:r>
                      <a:r>
                        <a:rPr lang="en-US" altLang="zh-CN" sz="7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:</a:t>
                      </a:r>
                      <a:endParaRPr lang="en-US" altLang="zh-CN" sz="700" b="1" i="0" u="none" strike="noStrike" baseline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</a:endParaRPr>
                    </a:p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 Ly6C</a:t>
                      </a:r>
                      <a:r>
                        <a:rPr lang="en-US" sz="700" b="1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gh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M Ly6C</a:t>
                      </a:r>
                      <a:r>
                        <a:rPr lang="en-US" sz="700" b="1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w</a:t>
                      </a:r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: 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  Ly6C</a:t>
                      </a:r>
                      <a:r>
                        <a:rPr lang="en-US" sz="700" b="1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w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/>
                </a:tc>
              </a:tr>
              <a:tr h="0">
                <a:tc vMerge="1">
                  <a:tcPr marL="4104" marR="4104" marT="41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(1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1DM(2</a:t>
                      </a:r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2DM(3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1DM(4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2DM(5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1DM(6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2DM(7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2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3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6F7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5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6A6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83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808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10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0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97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5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48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B8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4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2E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5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38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4EB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9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0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A9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9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BB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1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4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45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BCE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l15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9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B9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1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5D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7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F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0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8D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nfsf13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8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DA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4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AA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8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6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84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5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8C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4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4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CA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68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7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2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3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EB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1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9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5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3B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df3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9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BB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3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0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A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nfsf12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46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B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6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7A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nfsf1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4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B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2B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l1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2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1D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88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EA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9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2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2D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5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A8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0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7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3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ED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4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4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23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D7EC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fnk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2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3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17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4.7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AB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6.6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B8B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02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9BC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25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1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3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13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3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C3E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5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B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15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3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16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1E9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5EB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5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sf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5.1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81A6D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6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CCFE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0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BB9BC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l18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4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AE4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1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nfsf10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5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E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nfsf9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l17c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FE7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l7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3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C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5ECF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28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2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l2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8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FC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5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df15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3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1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5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9CC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l6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7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E0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4.5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FAFD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6.7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4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2C5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xcl12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9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DB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5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4.6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AED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df1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2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D7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22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4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4.4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0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1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C8E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6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1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8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D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nfsf8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8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CDE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6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BEE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4.0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B7D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4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2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0C6E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2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4.1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B6D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2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1D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tb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2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EC5E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5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C0E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8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DA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cl5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3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BC3E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9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A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1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76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CEE8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nfsf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4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1E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3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C3E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8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D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05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Xcl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5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C0E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0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A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3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2.75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CEE8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fng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4.1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B6D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6.4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18FC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3.1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2C8E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-1.82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3946" marR="3946" marT="39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EF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3492500" y="675005"/>
          <a:ext cx="2867660" cy="4698385"/>
        </p:xfrm>
        <a:graphic>
          <a:graphicData uri="http://schemas.openxmlformats.org/drawingml/2006/table">
            <a:tbl>
              <a:tblPr/>
              <a:tblGrid>
                <a:gridCol w="389890"/>
                <a:gridCol w="288290"/>
                <a:gridCol w="359410"/>
                <a:gridCol w="360045"/>
                <a:gridCol w="360045"/>
                <a:gridCol w="360045"/>
                <a:gridCol w="360045"/>
                <a:gridCol w="389890"/>
              </a:tblGrid>
              <a:tr h="252095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ytokine r</a:t>
                      </a:r>
                      <a:r>
                        <a:rPr lang="en-US" altLang="zh-C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eceptor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 Ly6C</a:t>
                      </a:r>
                      <a:r>
                        <a:rPr lang="en-US" sz="7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gh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: Ly6C</a:t>
                      </a:r>
                      <a:r>
                        <a:rPr lang="en-US" sz="7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w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/>
                </a:tc>
                <a:tc hMerge="1"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M </a:t>
                      </a:r>
                      <a:r>
                        <a:rPr lang="en-US" altLang="zh-C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Ly6C</a:t>
                      </a:r>
                      <a:r>
                        <a:rPr lang="en-US" altLang="zh-CN" sz="700" b="1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high</a:t>
                      </a:r>
                      <a:r>
                        <a:rPr lang="en-US" altLang="zh-CN" sz="7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:</a:t>
                      </a:r>
                      <a:endParaRPr lang="en-US" altLang="zh-CN" sz="700" b="1" i="0" u="none" strike="noStrike" baseline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</a:endParaRPr>
                    </a:p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 Ly6C</a:t>
                      </a:r>
                      <a:r>
                        <a:rPr lang="en-US" sz="700" b="1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gh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M Ly6C</a:t>
                      </a:r>
                      <a:r>
                        <a:rPr lang="en-US" sz="700" b="1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w</a:t>
                      </a:r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: 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  Ly6C</a:t>
                      </a:r>
                      <a:r>
                        <a:rPr lang="en-US" sz="700" b="1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w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/>
                </a:tc>
              </a:tr>
              <a:tr h="122555">
                <a:tc vMerge="1">
                  <a:tcPr marL="4104" marR="4104" marT="410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(1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1DM(2</a:t>
                      </a:r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2DM(3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1DM(4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2DM(5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1DM(6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2DM(7)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104" marR="4104" marT="410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r2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3.7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4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9C9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9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898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2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CB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4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C2C4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cr2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3.6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6B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3.0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48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7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8F9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1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Acvr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8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E9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0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DA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Acvr2b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5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99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3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4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0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4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1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FD2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sf3r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3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EA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6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DC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81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5B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Ltbr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2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5A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5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FC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3ra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9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FB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29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2A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0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2D5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Fas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7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8B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5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0C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55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89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1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4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fngr2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4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27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0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4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sf2ra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4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5C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0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3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Acvr1b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2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CC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20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D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x3cr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1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fngr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1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1D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1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ED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sf1r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0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3D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7ra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0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4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d27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5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1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rl2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6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3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7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Lifr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7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D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4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4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5C7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7r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7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CDE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6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E0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3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8CA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d40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8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D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0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B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cr3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9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A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4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3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8C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2.0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AAD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cr4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2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5E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cr5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9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A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1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cr9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0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xcr2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0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3.2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4E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81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5B8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7rb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02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9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B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2rb2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22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3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4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2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5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1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4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F2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xcr3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41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4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4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D2E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21r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9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B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1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D7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3.2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EC5E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2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r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9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A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2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C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8rap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5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3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4E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3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4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2rb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9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A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3.7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BDD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3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3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9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9E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0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9ED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27ra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9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5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4.3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B2D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5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1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8r1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3.0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C8E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7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CCE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9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1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9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5ra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4.0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B7D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3.62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BEE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4.1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B5D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1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12rb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4.08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B6D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Lepr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4.1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B6D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3.29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C4E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4.4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0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Il9r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4.57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ED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5.51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9ED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6.7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95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B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40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Ccr6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4.86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7A9D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2.2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5.0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A6D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04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-1.83 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D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/>
                          <a:ea typeface="宋体" panose="02010600030101010101" pitchFamily="2" charset="-122"/>
                        </a:rPr>
                        <a:t>1.75 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/>
                        <a:ea typeface="宋体" panose="02010600030101010101" pitchFamily="2" charset="-122"/>
                      </a:endParaRPr>
                    </a:p>
                  </a:txBody>
                  <a:tcPr marL="4185" marR="4185" marT="41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8BA"/>
                    </a:solidFill>
                  </a:tcPr>
                </a:tc>
              </a:tr>
            </a:tbl>
          </a:graphicData>
        </a:graphic>
      </p:graphicFrame>
      <p:sp>
        <p:nvSpPr>
          <p:cNvPr id="6" name="TextBox 661"/>
          <p:cNvSpPr txBox="1"/>
          <p:nvPr/>
        </p:nvSpPr>
        <p:spPr>
          <a:xfrm>
            <a:off x="310114" y="354404"/>
            <a:ext cx="6787372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dentification of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ignal 3 DEG pro-inflammatory </a:t>
            </a:r>
            <a:r>
              <a:rPr lang="en-US" altLang="zh-CN" sz="9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ligand/receptor genes in diabetic Ly6C MC subsets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3"/>
          <p:cNvSpPr txBox="1"/>
          <p:nvPr/>
        </p:nvSpPr>
        <p:spPr>
          <a:xfrm>
            <a:off x="421717" y="5725553"/>
            <a:ext cx="6042835" cy="860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>
                <a:latin typeface="Arial" panose="020B0604020202020204"/>
                <a:ea typeface="宋体" panose="02010600030101010101" pitchFamily="2" charset="-122"/>
                <a:sym typeface="+mn-ea"/>
              </a:rPr>
              <a:t>Supplementary Figure</a:t>
            </a:r>
            <a:r>
              <a:rPr lang="en-US" altLang="en-US" sz="1000" b="1" dirty="0">
                <a:sym typeface="+mn-ea"/>
              </a:rPr>
              <a:t> </a:t>
            </a:r>
            <a:r>
              <a:rPr lang="en-US" altLang="zh-CN" sz="1000" b="1">
                <a:latin typeface="Arial" panose="020B0604020202020204"/>
                <a:ea typeface="宋体" panose="02010600030101010101" pitchFamily="2" charset="-122"/>
                <a:sym typeface="+mn-ea"/>
              </a:rPr>
              <a:t>3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dentification of </a:t>
            </a:r>
            <a:r>
              <a:rPr lang="en-US" altLang="zh-CN" sz="1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 3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EG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ro-inflammatory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gene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 in diabetic Ly6C MC subsets. A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dentification of Signal 3 DEG pro-inflammatory </a:t>
            </a:r>
            <a:r>
              <a:rPr lang="en-US" altLang="zh-CN" sz="10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ligand genes. Heatmap color density indicates the average expression level of a given gene normalized by z-score. Red/blue rainbow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ackground in the table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resents the gradient of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creased/reduced fold change (log</a:t>
            </a:r>
            <a:r>
              <a:rPr kumimoji="0" lang="en-US" altLang="zh-CN" sz="1000" b="0" i="0" u="none" strike="noStrike" kern="1200" cap="none" spc="0" normalizeH="0" baseline="-25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C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 and log</a:t>
            </a:r>
            <a:r>
              <a:rPr kumimoji="0" lang="en-US" altLang="zh-CN" sz="1000" b="0" i="0" u="none" strike="noStrike" kern="1200" cap="none" spc="0" normalizeH="0" baseline="-25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C&lt;-1, respectively)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lang="en-US" altLang="zh-CN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261"/>
          <p:cNvSpPr>
            <a:spLocks noChangeArrowheads="1"/>
          </p:cNvSpPr>
          <p:nvPr/>
        </p:nvSpPr>
        <p:spPr bwMode="auto">
          <a:xfrm>
            <a:off x="4535805" y="36195"/>
            <a:ext cx="2322195" cy="3054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no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/>
                <a:ea typeface="宋体" panose="02010600030101010101" pitchFamily="2" charset="-122"/>
                <a:sym typeface="+mn-ea"/>
              </a:rPr>
              <a:t>Supplementary Figure</a:t>
            </a:r>
            <a:r>
              <a:rPr lang="en-US" altLang="en-US" sz="1400" b="1" dirty="0"/>
              <a:t> 3</a:t>
            </a:r>
            <a:endParaRPr lang="en-US" altLang="en-US" sz="1400" b="1" dirty="0"/>
          </a:p>
        </p:txBody>
      </p:sp>
      <p:sp>
        <p:nvSpPr>
          <p:cNvPr id="7" name="Rectangle 171"/>
          <p:cNvSpPr/>
          <p:nvPr/>
        </p:nvSpPr>
        <p:spPr>
          <a:xfrm>
            <a:off x="604149" y="5529914"/>
            <a:ext cx="5070772" cy="198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685800">
              <a:defRPr/>
            </a:pP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Bold letters indicate gene expression changes consistent in </a:t>
            </a:r>
            <a:r>
              <a:rPr lang="en-US" sz="70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Ly6C</a:t>
            </a:r>
            <a:r>
              <a:rPr lang="en-US" sz="70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high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MC in all three groups of mice.</a:t>
            </a:r>
            <a:endParaRPr lang="en-US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74955" y="631190"/>
          <a:ext cx="6243320" cy="8644255"/>
        </p:xfrm>
        <a:graphic>
          <a:graphicData uri="http://schemas.openxmlformats.org/drawingml/2006/table">
            <a:tbl>
              <a:tblPr/>
              <a:tblGrid>
                <a:gridCol w="411480"/>
                <a:gridCol w="309245"/>
                <a:gridCol w="308610"/>
                <a:gridCol w="411480"/>
                <a:gridCol w="4802505"/>
              </a:tblGrid>
              <a:tr h="21399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Upstream Regulator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Log</a:t>
                      </a:r>
                      <a:r>
                        <a:rPr lang="en-US" sz="700" b="0" i="0" u="none" strike="noStrike" baseline="-25000">
                          <a:effectLst/>
                          <a:latin typeface="Arial" panose="020B0604020202020204" pitchFamily="34" charset="0"/>
                        </a:rPr>
                        <a:t>2</a:t>
                      </a:r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FC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 z-score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Target Molecules in Dataset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85407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CEBPA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3.126</a:t>
                      </a:r>
                      <a:endParaRPr lang="en-US" altLang="zh-CN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.724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5.18E-11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bcb1b,ACOD1,AKAP12,AKR1C3,ALOX5AP,ANPEP,ANXA1,APLNR,APOB,ARL6IP5,ASS1,BCL2,BCL2A1,BIN1,C3,CCL4,Ccl9,CCNA2,CCND1,CCND2,CCR1,CD14,CD19,CD3G,CDH1,CDKN1A,CEBPA,CEBPD,CEBPE,COX4I1,CRADD,CSF3R,CTSK,CYP11A1,E2F1,EBF1,EFNB2,EGR2,EPHA7,EPHX1,F9,FABP4,FCGR1A,FLT1,FOS,FOXM1,FOXO1,G0S2,GATA2,GGH,GLI1,GLRX,HMOX1,HP,HSD11B1,ICAM1,ICAM2,IGF1,IKZF3,IL1RN,IL6,IL6R,IRF6,ISG15,ITGAX,JUN,KLF5,KLRC1,LCK,LCN2,LPL,LTF,Ly6a,MAPKAPK2,MMP8,MPO,MSI2,MYC,NFIL3,NRP1,OAS2,OVOL1,PAX5,PFN2,PGD,PLOD2,PLXND1,PPARD,PPARG,PPARGC1A,PPL,PRDM1,PRTN3,PTAFR,PTGS2,RAB31,RARRES2,RGL1,RIN1,S100A8,S100A9,S100G,Saa3,SCD,SERPINB2,SERPINI1,SMPDL3A,SPINT2,SPNS2,SPP1,TBXAS1,THRA,TIAM1,TNFRSF11A,TNFRSF19,TRIB1,VCAN,ZNF296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</a:tr>
              <a:tr h="53403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MITF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.861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-2.247</a:t>
                      </a:r>
                      <a:endParaRPr lang="en-US" altLang="zh-CN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18E-05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cp5,AMDHD2,AP1S2,APOLD1,ASAH1,ATP6V1B2,BCL2,BEST1,CCNB1,CCNF,CDC25B,CDCA8,CDKN1A,CENPF,CEP55,CHAF1A,CMA1,COX4I1,CREM,CTSK,DCSTAMP,FN1,FOS,FRMD4B,GLI1,GPR137B,Gzmb,HES1,IL6R,INPP4B,ITGA3,KIF4A,KIT,LGALS3,LIG1,MCM2,MCM5,MCM6,Mcpt4,MDC1,MET,MITF,NCAPD2,NDST2,NGFR,NPM3,POLD1,PPARGC1A,PRF1,SCARB1,SDC1,SLC19A2,SLC24A5,SLC7A8,SORT1,SOX13,SOX5,ST3GAL6,STXBP1,TBC1D16,TDRD7,TERT,TPSAB1/TPSB2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CEBPE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.462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.054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9.51E-08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LOX5AP,BCL2,Ccl9,CCND2,CCNE1,CD14,CLEC10A,CSF3R,CTSV,IL12A,IL1RN,IL5RA,IL6,LCN2,LTF,LYZ,MMP2,MMP8,MYC,Ngp,PTGS2,Retnlg,RNASE2,SERPINB2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339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IRF7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1.991</a:t>
                      </a:r>
                      <a:endParaRPr lang="en-US" altLang="zh-CN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.774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3.8E-11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DAR,BC147527,Ccl2,CCL5,CD69,CMPK2,CTLA4,CXCL10,DAXX,DHX58,FCGR1A,GBP3,IFI16,Ifi47,IFIH1,IFIT1,IFIT1B,IFIT2,IFIT3,IFITM2,IFITM3,Ifnz,IL12A,IL4I1,IRF7,Irgm1,ISG15,ITGAX,LILRA5,Ly6a ,Ms4a4c,Mx1,Mx2,OAS1,OAS2,OAS3,OASL,Oasl2,PARP12,PARP14,PLAC8,PLSCR1,RTP4,S100A8,SAP30,Slfn1,SOCS1,STAT1,STAT2,TAP2,TDRD7,TLR8,TMPO,TRAF1,TREX1,Trim30a/Trim30d,USP18,XAF1,ZBP1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E2F2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.21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2.449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0.00269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BCL2,CASP6,CCNA2,CCNB1,CCND1,CCNE1,CDC6,CDKN1A,CDKN2C,E2F1,IL6,MCM2,MCM5,MCM6,MYB,MYC,ORC1,RAD51,Raet1d/Raet1e,TERT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2735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FOXM1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.201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3.261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87E-08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CE,ANXA1,AURKA,AXIN2,BUB1B,CCNA2,CCNB1,CCND1,CCND2,CCNE1,CCNF,CDC20,CDC25B,CDCA8,CDH1,CDKN1A,CENPE,CENPF,COMMD3-BMI1,CTNNAL1,CXCR3,FLT1,FOS,FOXM1,FUT4,GLB1,GTSE1,IGF1,IL1RN,IL6,JUN,KDR,LEF1,MET,MKI67,MMP2,MYC,PECAM1,PLAUR,PLK4,PTCH1,STMN1,TOP2A,VCAN,VIM,ZEB1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TRPS1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.09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.387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0.00121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LPL,BGLAP,CCNA2,CDC20,CENPF,ENPP1,FN1,FOXM1,GALNT3,GPR141,KIF11,MMP2,PACSIN1,RAMP1,TOP2A,ZEB1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6075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STAT1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.069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.312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8.2E-19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BCA1,ACOD1,ALPK1,APOBEC3B,AXL,BAD,BAX,C1R,C3,CASP6,Ccl2,CCL3L3,CCL4,CCL5,CCND1,CCND2,CCNE1,CCR6,CCR7,CD14,CD274,CDKN1A,CEBPD,CFB,Chil3/Chil4,CMPK2,CREM,CSF3R,CTSS,CXCL10,Cxcl9,CXCR3,CYSLTR2,DCSTAMP,EGR1,EIF2AK2,FAS,FASLG,FCGR1A,FOS,FOXO1,FURIN,GATA3,GBP3,GBP6,Gzmb,HAVCR2,HES1,HLA-DQA1,HLA-DRB5,HLAE,ICAM1,IFI16,IFI30,Ifi47,IFIH1,IFIT1,IFIT1B,IFIT2,IFIT3,IFITM2,IFITM3,IFNG,IGF1,IL12A,IL12RB2,IL31RA,IL6,IRF7,Irgm1,ISG15,ITGAX,JUN,KCTD12,Klrk1,LCN2,Ly6a,MAFA,Mx1,Mx2,MYC,NFE2,OAS1,OAS2,OAS3,OASL,Oasl2,PDCD1LG2,PDGFRB,PECAM1,PLSCR1,PPARG,PRF1,PTGS2,RARB,RNF213,RTP4,SAMHD1,Serpina3g,SLAMF8,Slfn1,SLFN12L,SLFN13,Slfn2,SLFN5,SMAGP,SOAT1,SOCS1,SORT1,SP110,STAT1,STAT2,TBX21,TLR8,TRAFD1,USP18,Wfdc17,XAF1,ZBP1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2735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PML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1.148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.263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91E-06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CACB,AKR1A1,AKR7A2,ANXA4,BAX,CCND1,CCNE1,CDKN1A,CEBPE,DNAJA4,DNAJC9,FAS,Gzmb,HLA-DMB,HMOX1, HSPB1,IFIH1,IFIT1,IFIT3,IRF7,ISG15,JUP,LDLR,LIPC,LPL,LYZ,MAF,MAPK11,MCM6,Mx1,NDRG1,OAS1,OAS2,OAS3,PLSCR1,PML,PPARGC1A,PRKCA,RRAS2,RXRA,SCD,STAT1,STMN1,TAP2,TRIO,VIM,ZEB1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3403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MYB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1.473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2.796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2.33E-10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2900026A02Rik,ACAP1,ANPEP,AURKA,AXIN2,BANK1,BAX,BCL2,BHLHE40,BLNK,C3,CAMK2B,CASP6,Ccl2,CCNB1,CCND1,CCNE1,CD14,CDH1,CLTA,FN1,FOXM1,FOXO1,GATA3,GFI1,GIMAP1-GIMAP5,GIMAP7,GRAP,HERC3,ICAM1,IGF1, IKBKE, IL18R1,IL2RA,IL6,JUN,KDR,KIT,LCN2,MTSS1,MYB,MYC,MZB1,NOD2,NOTCH1,P2RY13,PRAG1,PRTN3,PTGS2,RYK,SDC1,SDC4,Serpina3g,Slfn2,SPP1,TFEC,TNFRSF13C,TNFRSF9,VIM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50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TCF7L2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2.635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2.454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8.83E-05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BCD2,ABHD17B,ACSL3,ALDH1A2,ALOX5,ANXA1,AQP9,ARAP2,AXIN2,BIN1,CAMK2N1,CCND1,CCND2,CDKN1A,CNP,CTNNAL1,DEGS1,DOCK9,EHHADH,ENPP4,ENTPD5,EPCAM,EVI2A,EVI2B,FMNL2,FNTB,FRMD4A,GAB1,GLTP,GLUL,GRAMD2B,GSN,ID3,IDH1,JAG1,KIF19,KLHL4,LAMP1,LEF1,MAFA,MAN1A1,MAP7,MCAM,MYC,MYO6,NKX6-2,NPC2,OTUD7B,PIGA, PKD1,PLEKHG1,PPARGC1A,PPP1R16B,PRICKLE1,PTPDC1,RAB31,RALGDS,RASGEF1B,REEP3,RHOG,RNASE4,SLC12A2,SLC22A23,SORBS3,SPP1,SRD5A1,STK39,SYTL2,TMEM123,TMEM141,TMEM163,TPPP,TSPAN2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067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EGR2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3.101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2.471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0.000162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CVR1,ASS1,BCL2,BGLAP,BHLHE40,CAMK4,CDKN1A,EGR1,EGR2,EPHA4,FASLG,FCER2,FLOT2,FOS,GATA3,ID3,IFNG,IL6R,ITGAE,JUN,KDR,MAPK8IP1,MYB,MYC,NOTCH1,PASK,PDE7A,PLCL1,PMP22,PPT2,PRDM1,RRAD,SCD,SLC12A2,SLC16A1,SOCS1,TBX21,TFRC,TGFBR3,TNFRSF8,TXNRD2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342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MYC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4.217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3.115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25E-09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ABCA1,ABCA7,ABCC3,ACOD1,ACSS1,ACVR1,ACVR2A,ADARB1,AHR,AKAP12,ALOX5,ANXA4,ANXA5,APP,Arf2,ARHGAP22,ASCL2,ASS1,ATAD3A,AXL,BAX,BCL2,BCL2A1,BCR,BIN1,BUB1B,CAD,CAMK2N1,CAPN2,Ccl6,CCNA2,CCNB1,CCND1,CCND2,CCNE1,CD19,CD274,CD69,CDC20,CDC25B,CDCA7,CDH1,CDKN1A,CEBPA,CEBPD,CEBPE,CHRNB1,CHST15,CIAO2A,CLPB,CNP,COBLL1,COL14A1,COL8A1,COMMD3-BMI1,COX7A2L,CRIP1,Crip2,Crisp1/Crisp3,CRYAB,CSTB, CTDSPL, CTNNAL1,CTSV,CXCL10,CYFIP2,CYTH2,DBI,DDB2,DDIT4,DDX11,DUSP2,DUSP4,DUSP5,DUSP6,DUSP7,E2F1,E2F2,Ear2,EBF1,EGR1,EGR2,EIF4EBP1,ENO1,EOMES,EPCAM,F2R,FABP4,FABP5,FARP1,FAS,FASLG,FGFR1,FN1,FOS,FOXM1,G6PD,GABARAP,GADD45G,GAMT,GBP3,GGH,GLS2,GLUD1,GLUL,GPC1,GRK4,GSR,H2AZ1,HES1,HIVEP2,HK2,HLA-A,HLA-E,HMOX1,HMOX2,HRAS,HSP90AA1,Hspa1b,HSPB1,ICAM1,ID3,IDH1,IDH2,IFI16,IFIH1,IFIT1,IFIT2,IFIT3,Igha,IL5RA,IQGAP2,IRF6,IRF7,ITGA1,ITGA3,ITGAX,ITM2B,JUN,KDR,LAMP1,LAMP2,LDHB,LXN,Ly6a,LYZ,MAD2L1,MCM5,MCM6,MGST3,MITF,MKI67,Mt1,MTFR2,MTHFR,MYC,MYD88,NCKAP1,NDRG1,NFAT5,NFATC3,NIBAN1,NME2,NOP58,NRP1,OAS1,OASL,Oasl2,OVOL1,PAK1,PAX5,PDGFRB,Pdlim3,PECAM1,PFKFB1,PKM,PLAU,PLAUR,PLSCR1,PML,PMP22,POLD1,PPARD,PPAT,PPL,PRDM1,PRKCA,Prl2c2,PTGS2,RAD51,RARA,RARB,RARG,RBBP7,RHOB,RPS27A,RPS27L,RRM2B,S100A6,SAT1,SCARB1,SCD,SCEL,SCPEP1,SEMA4A,SHMT2,SLC16A1,SLC22A4,SLC25A19,SLC25A5,SOX5,SPN,SPP1,SRD5A1,SRM,STAT1,STMN1,TAT,Tcf7,TERT,TES,TESPA1,TF,TFRC,TGFB1,TGM1,THOP1,TIAM1,TIMM10B,TIMP2,TMEM97,TNFRSF12A,TNFRSF19,TNFRSF8,TNNI3,TNNT3,TNS3,TPD52,TSPO,TWSG1,UGT1A1,UGT1A3,UGT1A6,UQCRQ,USP18,USP36,VDAC2,VEGFC,VIM,ZEB1,ZFP36L1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PAX5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4.469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2.617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1.42E-06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BCL2,BLK,BLNK,CCND1,CD19,CD22,CD72,CD79A,CR2,FCER2,FN1,G6PD,HK2,JCHAIN,MET,MMP2,POU2AF1,PRDM1,PTPRF,PYGL,SDC1,TNFRSF13C,VIM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067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TBX21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-4.655</a:t>
                      </a:r>
                      <a:endParaRPr lang="en-US" altLang="zh-CN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-2.983</a:t>
                      </a:r>
                      <a:endParaRPr lang="en-US" altLang="zh-CN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5.95E-12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CCL3L3,CCL4,CCR5,CD38,CXCR3,CXCR5,EOMES,FAM89B,FASLG,GATA3,GZMA,Gzmb,HAVCR2,HLX,ICOS,IFNG,IL12RB2,IL18RAP,IL1RL1,IL2RB,IL6R,ITGAE,ITK,KLRD1,KLRG1,Klrk1,NKG7,PRDM1,PRF1,PTGDR2,SPP1,STAT4,TBX21,Tcf7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4291965" y="0"/>
            <a:ext cx="268986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600" b="1">
                <a:latin typeface="Arial" panose="020B0604020202020204"/>
                <a:ea typeface="宋体" panose="02010600030101010101" pitchFamily="2" charset="-122"/>
                <a:sym typeface="+mn-ea"/>
              </a:rPr>
              <a:t>Supplementary Table </a:t>
            </a:r>
            <a:r>
              <a:rPr lang="en-US" altLang="zh-CN" sz="1600" b="1">
                <a:latin typeface="Arial" panose="020B0604020202020204"/>
                <a:ea typeface="Arial" panose="020B0604020202020204"/>
                <a:sym typeface="+mn-ea"/>
              </a:rPr>
              <a:t>1a</a:t>
            </a:r>
            <a:endParaRPr lang="en-US" altLang="zh-CN" sz="1600" b="1" i="0" u="none" strike="noStrike" dirty="0">
              <a:solidFill>
                <a:srgbClr val="4472C4"/>
              </a:solidFill>
              <a:effectLst/>
              <a:latin typeface="Arial" panose="020B0604020202020204"/>
              <a:ea typeface="Arial" panose="020B0604020202020204"/>
              <a:cs typeface="Arial" panose="020B0604020202020204" pitchFamily="34" charset="0"/>
              <a:sym typeface="+mn-ea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53035" y="356235"/>
            <a:ext cx="6828790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900" b="1" dirty="0">
                <a:latin typeface="Arial" panose="020B0604020202020204"/>
                <a:ea typeface="宋体" panose="02010600030101010101" pitchFamily="2" charset="-122"/>
                <a:sym typeface="+mn-ea"/>
              </a:rPr>
              <a:t>Supplementary Table 1a. DEG TF matching with the corresponding DEG in </a:t>
            </a:r>
            <a:r>
              <a:rPr lang="en-US" altLang="zh-CN" sz="9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1DM</a:t>
            </a:r>
            <a:r>
              <a:rPr lang="en-US" altLang="zh-CN" sz="900" b="1" dirty="0">
                <a:latin typeface="Arial" panose="020B0604020202020204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9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Ly6C</a:t>
            </a:r>
            <a:r>
              <a:rPr lang="en-US" altLang="zh-CN" sz="900" b="1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high </a:t>
            </a:r>
            <a:r>
              <a:rPr lang="en-US" altLang="zh-CN" sz="9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vs. T1DM Ly6C</a:t>
            </a:r>
            <a:r>
              <a:rPr lang="en-US" altLang="zh-CN" sz="900" b="1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low </a:t>
            </a:r>
            <a:r>
              <a:rPr lang="en-US" altLang="zh-CN" sz="9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MC</a:t>
            </a:r>
            <a:r>
              <a:rPr lang="en-US" altLang="zh-CN" sz="900" b="1" i="0" u="none" strike="noStrike" dirty="0">
                <a:solidFill>
                  <a:srgbClr val="4472C4"/>
                </a:solidFill>
                <a:effectLst/>
                <a:latin typeface="Arial" panose="020B0604020202020204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</a:t>
            </a:r>
            <a:endParaRPr lang="en-US" altLang="zh-CN" sz="900" b="1" i="0" u="none" strike="noStrike" dirty="0">
              <a:solidFill>
                <a:srgbClr val="4472C4"/>
              </a:solidFill>
              <a:effectLst/>
              <a:latin typeface="Arial" panose="020B0604020202020204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09550" y="9348470"/>
            <a:ext cx="6374765" cy="3987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000" b="1">
                <a:latin typeface="Arial" panose="020B0604020202020204"/>
                <a:ea typeface="宋体" panose="02010600030101010101" pitchFamily="2" charset="-122"/>
                <a:sym typeface="+mn-ea"/>
              </a:rPr>
              <a:t> Supplementary Table </a:t>
            </a:r>
            <a:r>
              <a:rPr lang="en-US" altLang="zh-CN" sz="1000" b="1">
                <a:latin typeface="Arial" panose="020B0604020202020204"/>
                <a:ea typeface="Arial" panose="020B0604020202020204"/>
                <a:sym typeface="+mn-ea"/>
              </a:rPr>
              <a:t>1a.</a:t>
            </a:r>
            <a:r>
              <a:rPr lang="en-US" altLang="zh-CN" sz="1000">
                <a:latin typeface="Arial" panose="020B0604020202020204"/>
                <a:ea typeface="Arial" panose="020B0604020202020204"/>
                <a:sym typeface="+mn-ea"/>
              </a:rPr>
              <a:t> </a:t>
            </a:r>
            <a:r>
              <a:rPr lang="en-US" altLang="zh-CN" sz="1000">
                <a:latin typeface="Arial" panose="020B0604020202020204"/>
                <a:ea typeface="宋体" panose="02010600030101010101" pitchFamily="2" charset="-122"/>
              </a:rPr>
              <a:t>The detailed list of DEG TF matching with the corresponding DEG </a:t>
            </a:r>
            <a:r>
              <a:rPr lang="en-US" altLang="zh-CN" sz="1000">
                <a:latin typeface="Arial" panose="020B0604020202020204"/>
                <a:ea typeface="宋体" panose="02010600030101010101" pitchFamily="2" charset="-122"/>
                <a:sym typeface="+mn-ea"/>
              </a:rPr>
              <a:t>in </a:t>
            </a:r>
            <a:r>
              <a:rPr lang="en-US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1DM</a:t>
            </a:r>
            <a:r>
              <a:rPr lang="en-US" altLang="zh-CN" sz="1000">
                <a:latin typeface="Arial" panose="020B0604020202020204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Ly6C</a:t>
            </a:r>
            <a:r>
              <a:rPr lang="en-US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high </a:t>
            </a:r>
            <a:r>
              <a:rPr lang="en-US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vs. T1DM Ly6C</a:t>
            </a:r>
            <a:r>
              <a:rPr lang="en-US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low </a:t>
            </a:r>
            <a:r>
              <a:rPr lang="en-US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MC.</a:t>
            </a:r>
            <a:r>
              <a:rPr lang="en-US" altLang="zh-CN" sz="1000" dirty="0">
                <a:solidFill>
                  <a:srgbClr val="4472C4"/>
                </a:solidFill>
                <a:effectLst/>
                <a:latin typeface="Arial" panose="020B0604020202020204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</a:t>
            </a:r>
            <a:endParaRPr lang="en-US" altLang="zh-CN" sz="1000">
              <a:latin typeface="Arial" panose="020B0604020202020204"/>
              <a:ea typeface="Arial" panose="020B0604020202020204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09550" y="765810"/>
          <a:ext cx="6595110" cy="6550270"/>
        </p:xfrm>
        <a:graphic>
          <a:graphicData uri="http://schemas.openxmlformats.org/drawingml/2006/table">
            <a:tbl>
              <a:tblPr/>
              <a:tblGrid>
                <a:gridCol w="431800"/>
                <a:gridCol w="288290"/>
                <a:gridCol w="259080"/>
                <a:gridCol w="395605"/>
                <a:gridCol w="5220335"/>
              </a:tblGrid>
              <a:tr h="213995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effectLst/>
                          <a:latin typeface="Arial" panose="020B0604020202020204" pitchFamily="34" charset="0"/>
                        </a:rPr>
                        <a:t>Upstream Regulator</a:t>
                      </a:r>
                      <a:endParaRPr lang="en-US" sz="7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Log</a:t>
                      </a:r>
                      <a:r>
                        <a:rPr lang="en-US" sz="700" b="0" i="0" u="none" strike="noStrike" baseline="-25000">
                          <a:effectLst/>
                          <a:latin typeface="Arial" panose="020B0604020202020204" pitchFamily="34" charset="0"/>
                        </a:rPr>
                        <a:t>2</a:t>
                      </a:r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FC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 z-score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Target Molecules in Dataset</a:t>
                      </a:r>
                      <a:endParaRPr 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1" marR="391" marT="391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7473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EBP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1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174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57E-09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bcb1b,ACSL1,AKAP12,AKR1C3,ALOX5AP,ANPEP,ANXA1,APCDD1,APLNR,APOB,ASS1,BCL2,BCL2A1,BHMT,BIN1,C3,CCL4,Ccl9,CCND2,CCR1,CD14,CD19,CD3G,CD7,CDH1,CEBPA,CEBPD,CEBPE,CIITA,COL10A1,COX4I1,CSF1,CSF2RA,CSF3R,CTSK,CYP11A1,DGAT2,DHFR,EBF1,EFNB2,EGR2,EPHX1,FABP4,FASN,FCGR1A,FOS,FOXM1,FOXO1,G0S2,GAPDH,GATA2,GATA6,GGH,GLIPR1,GLRX,HMOX1,HP,HSD11B1,ICAM2,IGF1,IKZF3,IL10,IL1RN,IL6,IL6R,ITGAM,ITGAX,JUN,JUNB,KLF5,KLRC1,KRT7,LCK,LCN2,LPL,Ly6a,MALT1,MAPKAPK2,MMP8,MPO,MSI2,MYC,NFIL3,NR4A2,OLR1,OVOL1,PAX5,PGD,PLOD2,PLXND1,PPARG,PPARGC1A,PPL,PRTN3,PTAFR,PTGS1,PTPN3,RAB31,S100A8,Saa3,SBSN,SCD,SERPINI1,SMPDL3A,SOD1,SPINT2,SPP1,TFAP2A,THBS1,THRA,TIAM1,TNFRSF11A,TNFRSF19,TRIB1,VCAN,ZNF29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KZF2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864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.35E-06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2,Cd52,CD69,FOXP3,GZMA,Gzmb,HLA-E,ICOS,IKZF3,IL10,IRF7,KLRG1,LAG3,Ly6a ,NR4A1,TNFRSF18,TNFSF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0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FI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3.69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78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.53E-07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TLA,CARD6,Ccl2,CCND2,CCR7,CD40,CD7,CEBPA,CEBPE,CEP95,CSF1,DDB2,DGKG,EGR2,ENTPD1,ETS1,ETS2,F2R,FOSL2,FOXO1,GADD45G,GFI1,GIMAP4,GPR183,GUSB,GZMA,IL10,IL6,IL6R,IL7R,JAK3,JUN,LPAR1,LTA,Ly6a,LYZ,MAFB,MAFF,MYC,NLRC5,PER3,Pmaip1,RASGRP1,S1PR1,SESN3,TNFSF1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432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XBP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04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029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13E-0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ACB,AFP,AICDA,APBB2,APP,ATF6B,BCL2,BET1,BHLHA15,Ccl2,CCL5,COPZ1,DOLPP1,ERP29,ETS1,FAS,FASLG,FASN,FKBP11,FN1,GMPPB,HLA-DRA,HM13,HMOX1,IL6,KDELR2,KDELR3,Klrk1,LMAN1,MAFA,MAN1A1,MCFD2,MYC,OSTC, P4HB,PDIA5, PDIA6,PGM3,POU2AF1,RCN3,RPN1,Rrbp1,S100A6,S1PR1,SCD,SEC24D,SEC61B,SEC61G,SLC1A5,SOD1,SRP19,SRP54,SRP9,SSR2,SSR3,SURF4,TRAM1,TXN,VAMP7,WFS1,WNT10B,XBP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ZEB1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407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215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00E+00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H1,FN1,ITGB4,NRP2,PLAU,TF,VIM,ZEB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cf7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3.204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491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14E-06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CL11B,BCL2,CCL3L3,CCL4,DTX1,EOMES,FASLG,FYN,GZMA,IL2RA,IL7R,KIT,Klra7,LEF1,SOCS2,SOX12,TBX21,TNFRSF19,TOX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IS2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.651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80E-0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3,Ccl2,CXCL10,VIM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IITA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.996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27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46E-02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74,FASLG,H2-Eb2,HLA-A,HLA-DMB,HLA-DOA,HLA-DOB,HLA-DQA1,HLA-DQB1,HLA-DRA,HLA-DRB5,IL10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AX5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5.632</a:t>
                      </a:r>
                      <a:endParaRPr lang="en-US" altLang="zh-CN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3.214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8E-07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CL2,BLK,BLNK,CD19,CD22,CD40,CD72,CD79A,CIITA,CR2,CSF2RA,FCER2,FN1,G6PD,GPRIN3,HK3,JCHAIN,MET,PGAM1,POU2AF1,PYGL,SDC1,SLC2A3,TNFRSF13C,VIM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473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CF3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.231</a:t>
                      </a:r>
                      <a:endParaRPr lang="en-US" altLang="zh-CN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384</a:t>
                      </a:r>
                      <a:endParaRPr lang="en-US" altLang="zh-CN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52E-18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ACB,ADA,AICDA,ANLN,ARSA,ATF3,AURKA,AXIN2,BACH2,BCL2L11,BHLHA15,BLNK,BTNL2,C15orf39,CASP6,CCNB1,CCND2,CCNE1,CCS,CD2,CD55,CD79A,CD79B,CDC25B,CDH1,CDKN2C,CDKN3,CELA1,CEP55,CIP2A,CR2,CREB3L2,CTSV,CYP11A1,DOCK1,DSTN,DTX1,EAF2,EBF1,EIF4EBP1,ENPP1,ENTPD1,EPCAM,ETS2,FGD2,FGFR3,FKBP11,FOXO1,FOXP3,GADD45B,GATA2,GFI1,GIMAP4,GNE,GPLD1,HMGB2,HS3ST1,HSD11B1,ICOS,ID3,IFI16,IGHM,IL2RA,IL7R,JUN,KCNN4,KIT,LEF1,LEPROTL1,LRBA,Ly6a,LY6D,MEF2C,MFSD13A,MYC,MZB1,NDC80,NFIL3,NOTCH1,OPTN,PAFAH1B3,PAX5,PDIA6,PGK1,PLPP5,PML,POU2AF1,PRDX2,PRDX4,PSAP,PTGS1,PTPRU,RIPOR2,RRM2,SCN4A,SEC24D,SELENOP,SELL,SEMA3G,Serpina3g ,SLAMF7,SLC12A2,SLC66A3,SMAGP,SULT2B1,TCEAL9,TCF3,TF,TMEFF1,TOP2A,TOX,TTK,VSIR,XBP1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BX2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415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03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71E-1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L3L3,CCL4,CCR4,CD38,CXCR5,EOMES,FAM89B,FASLG,GZMA,Gzmb,HAVCR2,HLX,ICOS,IL12RB2,IL18RAP,IL1RL1,IL2RB,IL6R,IL7R,ITGAE,ITK,KLRD1,KLRG1,Klrk1,NKG7,PRF1,PTGDR2,SELL,SPP1,TBX21,Tcf7,ZEB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FIL3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385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157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85E-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ATF3,EOMES,FAS,FASN,GADD45B,HAVCR2,IL10,SC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F2C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.806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55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77E-03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TN2,ATF3,ATP2A1,BACH2,BGLAP,BLK,Ccl2,CCL3L3,CCL4,Ccl6,Ccl9,CCR2,CKB,COL10A1,EGR2,FOS,HDAC9,IL6,ITGB1BP2,JUN,JUNB,MEF2C,MMP25,MMP8,MYOM2,NR4A1,PLAGL1,PPARGC1A,PTGS1,S100A4,SCN5A,SRPK3,VI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OU2AF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5.597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544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59E-0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ICDA,Akr1c12/Akr1c13,BTLA,CD69,CD79A,CD79B,Crisp1/Crisp3,CXCR5,HLA-DRA,ID3,IFIT3,IGHG1,IGHM,KCNN4, LCK, MS4A6A,PAX5,PTPRS,SPIB,SPP1,TNFRSF13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PIB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5.402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3.081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4E-0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F3,BLNK,BMP6,CCR2,CD200,CD209,Cd209d,CLEC10A,CLEC4G,CLEC4M,EGR2,EPCAM,GEM,Gm6377,HSPA1A/HSPA1B,Iglv2,IKZF3,IL2RA,KIT,Klra17,LGR5,LILRB3,MEF2C,P2RY10,SLAMF9,XBP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AV2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.923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37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23E-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TRAP,BCL2,BCL2A1,CCNE1,CD69,CDH1,FOS,IL6,RAC1,VI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60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OU2F2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007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781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.60E-07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DA,BANK1,BTLA,CD22,CD69,CD79B,CXCR5,EBF1,ENO1,FCRL1,GGA2,GPR183,HLA-DRA, IGKC,IL10,IL12A,IL5RA,JUN, KCNN4,LCK,MCM7,MOCOS,MS4A1,MYC,POU2F2,SCD,SPP1,TERT,TIMP2,TNFAIP2,TNFRSF12A,TNFRSF21,XBP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41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YC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3.322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.375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.14E-12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BCA1,ABCB9,ABCC3,ABCC4,ABCD3,ACAT1,ACSS1,ACTB,AFMID,AFP,AHR,AKAP1,AKAP12,ALDH18A1,ALDOA,ANGPT2,ANXA4,ANXA5,APCDD1,APP,AQP1,AR,Arf2,ASCL2,ASS1,ATAD3A,ATP5IF1,AURKB,BCKDHB,BCL2,BCL2A1,BIN1,BRCA1,CAMK2N1,CAV1,Ccl6,CCNB1,CCND2,CCNE1,CD19,CD274,CD69,CD9,CDC25B,CDCA7,CDH1,CEBPA,CEBPD,CEBPE,CHP1,CHRNB1,CHST15,CIAO2A,CLIC4,CLPB,CNP,COBLL1,Crisp1/Crisp3,CSRP2,CSTB,CTDSPL,CTSD,CTSV,CXCL10,CYFIP2,CYTH2,DBI,DBN1,DCTPP1,DDB2,DDIT4,DDX11,DHFR,DUSP2,DUSP4,DUSP5,DUSP6,DUSP7,E2F2,Ear2,EBF1,ECM1,EGR2,EIF2B4,EIF4EBP1,EMP1,ENO1,EOMES,EPCAM,F2R,FABP4,FABP5,FARP1,FAS,FASLG,FASN,FGFR1,FN1,FOS,FOXM1,FTH1,G6PD,GABARAP,GADD45B,GADD45G,GAMT,GAPDH,GATA6,GBP3,GGH,GLRX5,GLUD1,GLUL,GOT1,GOT2,GPI,GRPEL1,GSR,H2AZ1,H6PD,HAPLN1,HES1,HIF1A,HIVEP2,HLA-A,HLA-E,HMOX1,HSPB1,ID3,IDH1,IFI16, IFIT1,IFIT3,Igha,IL10,IL17RB,IL5RA,IMPA2,IQGAP2,IRF7,ITGA3,ITGAM,ITGAX,ITM2B,JUN,KHDC3L,KRT7,LAMP1,LAMP2,LDHB,LGMN,LGR5,LXN,Ly6a (includes others),LYZ,MCM6,MCM7,MGST3,MITF,MRC1,Mt1,MTBP,MTHFR,MYC,MYCT1,MYD88,MYO1C,NDRG1,NDUFS4,NIBAN1,NME2,NOP56,NOP58,OVOL1,PAM,PAX5,PCDH18,PDGFRB,Pdlim3,PDLIM7,PECAM1,PFKFB1,PFKM,PGAM1,PGK1,PKM,PLAU,PLK1,PLSCR1,PML,POLD1,POLR1B,POLR2D,PPL,PRDX2,PRDX3,PRDX4,PRKCA,Prl2c2,PYCR1,RARA,RARG,RBBP7,RHOB,RPL10,RPL6,RRM2,S100A6,SARDH,SCAMP1,SCARB1,SCEL,SDCBP,SEMA4A,SEPHS2,SIRT2,SLC16A7,SLC1A5,SLC22A4,SLC25A5,SLC2A3,SMS,SOX5,SPN,SPP1,SQOR,SRD5A1,ST3GAL3,SUCLA2,TAT,TCF3,Tcf7,TEAD2,TERT,TESPA1,TF,TFRC,TGM1,THBS1,THOP1,TIAM1,TIMM10B,TIMP2,TNFRSF12A,TNFRSF19,TNFRSF8,TNS3,TPD52,TSPAN7,TSPO,TWSG1,TXN,UGT1A6,ULBP1,VEGFC,VIM,WL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30" marR="430" marT="43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09550" y="7359650"/>
            <a:ext cx="6374765" cy="5530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000" b="1" dirty="0">
                <a:latin typeface="Arial" panose="020B0604020202020204"/>
                <a:ea typeface="宋体" panose="02010600030101010101" pitchFamily="2" charset="-122"/>
                <a:sym typeface="+mn-ea"/>
              </a:rPr>
              <a:t> Supplementary Table </a:t>
            </a:r>
            <a:r>
              <a:rPr lang="en-US" altLang="zh-CN" sz="1000" b="1" dirty="0">
                <a:latin typeface="Arial" panose="020B0604020202020204"/>
                <a:ea typeface="Arial" panose="020B0604020202020204"/>
                <a:sym typeface="+mn-ea"/>
              </a:rPr>
              <a:t>1.</a:t>
            </a:r>
            <a:r>
              <a:rPr lang="en-US" altLang="zh-CN" sz="1000" dirty="0">
                <a:latin typeface="Arial" panose="020B0604020202020204"/>
                <a:ea typeface="Arial" panose="020B0604020202020204"/>
                <a:sym typeface="+mn-ea"/>
              </a:rPr>
              <a:t> </a:t>
            </a:r>
            <a:r>
              <a:rPr lang="en-US" altLang="zh-CN" sz="1000" dirty="0">
                <a:latin typeface="Arial" panose="020B0604020202020204"/>
                <a:ea typeface="宋体" panose="02010600030101010101" pitchFamily="2" charset="-122"/>
              </a:rPr>
              <a:t>The detailed list of DEG TF matching with the corresponding DEG </a:t>
            </a:r>
            <a:r>
              <a:rPr lang="en-US" altLang="zh-CN" sz="1000" dirty="0">
                <a:latin typeface="Arial" panose="020B0604020202020204"/>
                <a:ea typeface="宋体" panose="02010600030101010101" pitchFamily="2" charset="-122"/>
                <a:sym typeface="+mn-ea"/>
              </a:rPr>
              <a:t>in </a:t>
            </a:r>
            <a:r>
              <a:rPr lang="en-US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2DM</a:t>
            </a:r>
            <a:r>
              <a:rPr lang="en-US" altLang="zh-CN" sz="1000" dirty="0">
                <a:latin typeface="Arial" panose="020B0604020202020204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Ly6C</a:t>
            </a:r>
            <a:r>
              <a:rPr lang="en-US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high </a:t>
            </a:r>
            <a:r>
              <a:rPr lang="en-US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vs. T2DM Ly6C</a:t>
            </a:r>
            <a:r>
              <a:rPr lang="en-US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low </a:t>
            </a:r>
            <a:r>
              <a:rPr lang="en-US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MC.</a:t>
            </a:r>
            <a:endParaRPr lang="en-US" altLang="zh-CN" sz="1000" i="0" u="none" strike="noStrike" dirty="0">
              <a:solidFill>
                <a:srgbClr val="4472C4"/>
              </a:solidFill>
              <a:effectLst/>
              <a:latin typeface="Arial" panose="020B0604020202020204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endParaRPr lang="en-US" altLang="zh-CN" sz="1000" dirty="0">
              <a:latin typeface="Arial" panose="020B0604020202020204"/>
              <a:ea typeface="Arial" panose="020B0604020202020204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159885" y="0"/>
            <a:ext cx="256476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600" b="1">
                <a:latin typeface="Arial" panose="020B0604020202020204"/>
                <a:ea typeface="宋体" panose="02010600030101010101" pitchFamily="2" charset="-122"/>
                <a:sym typeface="+mn-ea"/>
              </a:rPr>
              <a:t>Supplementary Table </a:t>
            </a:r>
            <a:r>
              <a:rPr lang="en-US" altLang="zh-CN" sz="1600" b="1">
                <a:latin typeface="Arial" panose="020B0604020202020204"/>
                <a:ea typeface="Arial" panose="020B0604020202020204"/>
                <a:sym typeface="+mn-ea"/>
              </a:rPr>
              <a:t>1b.</a:t>
            </a:r>
            <a:endParaRPr lang="en-US" altLang="zh-CN" sz="1600" b="1" i="0" u="none" strike="noStrike" dirty="0">
              <a:solidFill>
                <a:srgbClr val="4472C4"/>
              </a:solidFill>
              <a:effectLst/>
              <a:latin typeface="Arial" panose="020B0604020202020204"/>
              <a:ea typeface="Arial" panose="020B0604020202020204"/>
              <a:cs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53035" y="535940"/>
            <a:ext cx="6828790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900" b="1" dirty="0">
                <a:latin typeface="Arial" panose="020B0604020202020204"/>
                <a:ea typeface="宋体" panose="02010600030101010101" pitchFamily="2" charset="-122"/>
                <a:sym typeface="+mn-ea"/>
              </a:rPr>
              <a:t>Supplementary Table 1b. DEG TF matching with the corresponding DEG in </a:t>
            </a:r>
            <a:r>
              <a:rPr lang="en-US" altLang="zh-CN" sz="9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2DM</a:t>
            </a:r>
            <a:r>
              <a:rPr lang="en-US" altLang="zh-CN" sz="900" b="1" dirty="0">
                <a:latin typeface="Arial" panose="020B0604020202020204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9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Ly6C</a:t>
            </a:r>
            <a:r>
              <a:rPr lang="en-US" altLang="zh-CN" sz="900" b="1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high </a:t>
            </a:r>
            <a:r>
              <a:rPr lang="en-US" altLang="zh-CN" sz="9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vs. T2DM Ly6C</a:t>
            </a:r>
            <a:r>
              <a:rPr lang="en-US" altLang="zh-CN" sz="900" b="1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low </a:t>
            </a:r>
            <a:r>
              <a:rPr lang="en-US" altLang="zh-CN" sz="9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MC</a:t>
            </a:r>
            <a:r>
              <a:rPr lang="en-US" altLang="zh-CN" sz="900" b="1" i="0" u="none" strike="noStrike" dirty="0">
                <a:solidFill>
                  <a:srgbClr val="4472C4"/>
                </a:solidFill>
                <a:effectLst/>
                <a:latin typeface="Arial" panose="020B0604020202020204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</a:t>
            </a:r>
            <a:endParaRPr lang="en-US" altLang="zh-CN" sz="900" b="1" i="0" u="none" strike="noStrike" dirty="0">
              <a:solidFill>
                <a:srgbClr val="4472C4"/>
              </a:solidFill>
              <a:effectLst/>
              <a:latin typeface="Arial" panose="020B0604020202020204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TABLE_ENDDRAG_ORIGIN_RECT" val="225*384"/>
  <p:tag name="TABLE_ENDDRAG_RECT" val="267*46*225*384"/>
</p:tagLst>
</file>

<file path=ppt/tags/tag2.xml><?xml version="1.0" encoding="utf-8"?>
<p:tagLst xmlns:p="http://schemas.openxmlformats.org/presentationml/2006/main">
  <p:tag name="TABLE_ENDDRAG_ORIGIN_RECT" val="491*676"/>
  <p:tag name="TABLE_ENDDRAG_RECT" val="12*47*491*676"/>
</p:tagLst>
</file>

<file path=ppt/tags/tag3.xml><?xml version="1.0" encoding="utf-8"?>
<p:tagLst xmlns:p="http://schemas.openxmlformats.org/presentationml/2006/main">
  <p:tag name="TABLE_ENDDRAG_ORIGIN_RECT" val="519*455"/>
  <p:tag name="TABLE_ENDDRAG_RECT" val="16*60*519*455"/>
</p:tagLst>
</file>

<file path=ppt/tags/tag4.xml><?xml version="1.0" encoding="utf-8"?>
<p:tagLst xmlns:p="http://schemas.openxmlformats.org/presentationml/2006/main">
  <p:tag name="KSO_WPP_MARK_KEY" val="886d3ced-9972-44df-a591-df06f3091dac"/>
  <p:tag name="COMMONDATA" val="eyJoZGlkIjoiMzEwNTM5NzYwMDRjMzkwZTVkZjY2ODkwMGIxNGU0OTU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800" b="0" i="0" u="none" strike="noStrike" dirty="0" smtClean="0">
            <a:solidFill>
              <a:srgbClr val="4472C4"/>
            </a:solidFill>
            <a:effectLst/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357</Words>
  <Application>WPS 演示</Application>
  <PresentationFormat>A4 Paper (210x297 mm)</PresentationFormat>
  <Paragraphs>1437</Paragraphs>
  <Slides>6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8" baseType="lpstr">
      <vt:lpstr>Arial</vt:lpstr>
      <vt:lpstr>宋体</vt:lpstr>
      <vt:lpstr>Wingdings</vt:lpstr>
      <vt:lpstr>Arial</vt:lpstr>
      <vt:lpstr>等线</vt:lpstr>
      <vt:lpstr>MS PGothic</vt:lpstr>
      <vt:lpstr>微软雅黑</vt:lpstr>
      <vt:lpstr>Arial Unicode MS</vt:lpstr>
      <vt:lpstr>等线 Light</vt:lpstr>
      <vt:lpstr>Calibri Light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633</dc:creator>
  <cp:lastModifiedBy>杨萍萍</cp:lastModifiedBy>
  <cp:revision>2139</cp:revision>
  <dcterms:created xsi:type="dcterms:W3CDTF">2021-12-03T14:41:00Z</dcterms:created>
  <dcterms:modified xsi:type="dcterms:W3CDTF">2026-03-29T02:56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B00388121034ACAB4473BEDD74B026A_12</vt:lpwstr>
  </property>
  <property fmtid="{D5CDD505-2E9C-101B-9397-08002B2CF9AE}" pid="3" name="KSOProductBuildVer">
    <vt:lpwstr>2052-12.1.0.25225</vt:lpwstr>
  </property>
</Properties>
</file>